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1"/>
  </p:notesMasterIdLst>
  <p:sldIdLst>
    <p:sldId id="257" r:id="rId2"/>
    <p:sldId id="259" r:id="rId3"/>
    <p:sldId id="261" r:id="rId4"/>
    <p:sldId id="260" r:id="rId5"/>
    <p:sldId id="315" r:id="rId6"/>
    <p:sldId id="317" r:id="rId7"/>
    <p:sldId id="262" r:id="rId8"/>
    <p:sldId id="319" r:id="rId9"/>
    <p:sldId id="316" r:id="rId10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292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931"/>
    <p:restoredTop sz="94415"/>
  </p:normalViewPr>
  <p:slideViewPr>
    <p:cSldViewPr snapToGrid="0">
      <p:cViewPr>
        <p:scale>
          <a:sx n="130" d="100"/>
          <a:sy n="130" d="100"/>
        </p:scale>
        <p:origin x="504" y="-26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0F025F-E0EF-0442-9F08-E592EB3B2C59}" type="datetimeFigureOut">
              <a:rPr lang="en-US" smtClean="0"/>
              <a:t>8/30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F96174-2AB4-C54E-B652-67B0B90BE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8111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F96174-2AB4-C54E-B652-67B0B90BE15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19199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F96174-2AB4-C54E-B652-67B0B90BE15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88437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F96174-2AB4-C54E-B652-67B0B90BE150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28836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F96174-2AB4-C54E-B652-67B0B90BE150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57830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F96174-2AB4-C54E-B652-67B0B90BE150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91161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F96174-2AB4-C54E-B652-67B0B90BE150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4733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94057-2B14-BF4E-A10F-71373D00A90A}" type="datetimeFigureOut">
              <a:rPr lang="en-US" smtClean="0"/>
              <a:t>8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2F204-6E53-7048-85C1-CB80238CC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79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94057-2B14-BF4E-A10F-71373D00A90A}" type="datetimeFigureOut">
              <a:rPr lang="en-US" smtClean="0"/>
              <a:t>8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2F204-6E53-7048-85C1-CB80238CC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855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94057-2B14-BF4E-A10F-71373D00A90A}" type="datetimeFigureOut">
              <a:rPr lang="en-US" smtClean="0"/>
              <a:t>8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2F204-6E53-7048-85C1-CB80238CC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90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94057-2B14-BF4E-A10F-71373D00A90A}" type="datetimeFigureOut">
              <a:rPr lang="en-US" smtClean="0"/>
              <a:t>8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2F204-6E53-7048-85C1-CB80238CC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0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>
                    <a:tint val="82000"/>
                  </a:schemeClr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82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82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94057-2B14-BF4E-A10F-71373D00A90A}" type="datetimeFigureOut">
              <a:rPr lang="en-US" smtClean="0"/>
              <a:t>8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2F204-6E53-7048-85C1-CB80238CC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57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94057-2B14-BF4E-A10F-71373D00A90A}" type="datetimeFigureOut">
              <a:rPr lang="en-US" smtClean="0"/>
              <a:t>8/3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2F204-6E53-7048-85C1-CB80238CC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605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94057-2B14-BF4E-A10F-71373D00A90A}" type="datetimeFigureOut">
              <a:rPr lang="en-US" smtClean="0"/>
              <a:t>8/3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2F204-6E53-7048-85C1-CB80238CC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0897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94057-2B14-BF4E-A10F-71373D00A90A}" type="datetimeFigureOut">
              <a:rPr lang="en-US" smtClean="0"/>
              <a:t>8/3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2F204-6E53-7048-85C1-CB80238CC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0423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94057-2B14-BF4E-A10F-71373D00A90A}" type="datetimeFigureOut">
              <a:rPr lang="en-US" smtClean="0"/>
              <a:t>8/3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2F204-6E53-7048-85C1-CB80238CC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597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94057-2B14-BF4E-A10F-71373D00A90A}" type="datetimeFigureOut">
              <a:rPr lang="en-US" smtClean="0"/>
              <a:t>8/3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2F204-6E53-7048-85C1-CB80238CC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6388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94057-2B14-BF4E-A10F-71373D00A90A}" type="datetimeFigureOut">
              <a:rPr lang="en-US" smtClean="0"/>
              <a:t>8/3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2F204-6E53-7048-85C1-CB80238CC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390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8A94057-2B14-BF4E-A10F-71373D00A90A}" type="datetimeFigureOut">
              <a:rPr lang="en-US" smtClean="0"/>
              <a:t>8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62F204-6E53-7048-85C1-CB80238CC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5543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openxmlformats.org/officeDocument/2006/relationships/oleObject" Target="../embeddings/oleObject3.bin"/><Relationship Id="rId18" Type="http://schemas.openxmlformats.org/officeDocument/2006/relationships/image" Target="../media/image12.emf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emf"/><Relationship Id="rId12" Type="http://schemas.openxmlformats.org/officeDocument/2006/relationships/image" Target="../media/image8.png"/><Relationship Id="rId17" Type="http://schemas.openxmlformats.org/officeDocument/2006/relationships/image" Target="../media/image11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0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emf"/><Relationship Id="rId11" Type="http://schemas.openxmlformats.org/officeDocument/2006/relationships/image" Target="../media/image7.emf"/><Relationship Id="rId5" Type="http://schemas.openxmlformats.org/officeDocument/2006/relationships/image" Target="../media/image2.emf"/><Relationship Id="rId15" Type="http://schemas.openxmlformats.org/officeDocument/2006/relationships/oleObject" Target="../embeddings/oleObject4.bin"/><Relationship Id="rId10" Type="http://schemas.openxmlformats.org/officeDocument/2006/relationships/oleObject" Target="../embeddings/oleObject2.bin"/><Relationship Id="rId19" Type="http://schemas.openxmlformats.org/officeDocument/2006/relationships/image" Target="../media/image13.emf"/><Relationship Id="rId4" Type="http://schemas.openxmlformats.org/officeDocument/2006/relationships/image" Target="../media/image1.emf"/><Relationship Id="rId9" Type="http://schemas.openxmlformats.org/officeDocument/2006/relationships/image" Target="../media/image6.emf"/><Relationship Id="rId14" Type="http://schemas.openxmlformats.org/officeDocument/2006/relationships/image" Target="../media/image9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13" Type="http://schemas.openxmlformats.org/officeDocument/2006/relationships/image" Target="../media/image24.emf"/><Relationship Id="rId18" Type="http://schemas.openxmlformats.org/officeDocument/2006/relationships/image" Target="../media/image29.emf"/><Relationship Id="rId3" Type="http://schemas.openxmlformats.org/officeDocument/2006/relationships/image" Target="../media/image14.emf"/><Relationship Id="rId21" Type="http://schemas.openxmlformats.org/officeDocument/2006/relationships/image" Target="../media/image32.emf"/><Relationship Id="rId7" Type="http://schemas.openxmlformats.org/officeDocument/2006/relationships/image" Target="../media/image18.emf"/><Relationship Id="rId12" Type="http://schemas.openxmlformats.org/officeDocument/2006/relationships/image" Target="../media/image23.emf"/><Relationship Id="rId17" Type="http://schemas.openxmlformats.org/officeDocument/2006/relationships/image" Target="../media/image28.em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7.emf"/><Relationship Id="rId20" Type="http://schemas.openxmlformats.org/officeDocument/2006/relationships/image" Target="../media/image3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emf"/><Relationship Id="rId11" Type="http://schemas.openxmlformats.org/officeDocument/2006/relationships/image" Target="../media/image22.emf"/><Relationship Id="rId5" Type="http://schemas.openxmlformats.org/officeDocument/2006/relationships/image" Target="../media/image16.emf"/><Relationship Id="rId15" Type="http://schemas.openxmlformats.org/officeDocument/2006/relationships/image" Target="../media/image26.emf"/><Relationship Id="rId10" Type="http://schemas.openxmlformats.org/officeDocument/2006/relationships/image" Target="../media/image21.emf"/><Relationship Id="rId19" Type="http://schemas.openxmlformats.org/officeDocument/2006/relationships/image" Target="../media/image30.emf"/><Relationship Id="rId4" Type="http://schemas.openxmlformats.org/officeDocument/2006/relationships/image" Target="../media/image15.emf"/><Relationship Id="rId9" Type="http://schemas.openxmlformats.org/officeDocument/2006/relationships/image" Target="../media/image20.emf"/><Relationship Id="rId14" Type="http://schemas.openxmlformats.org/officeDocument/2006/relationships/image" Target="../media/image25.emf"/><Relationship Id="rId22" Type="http://schemas.openxmlformats.org/officeDocument/2006/relationships/image" Target="../media/image33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emf"/><Relationship Id="rId7" Type="http://schemas.openxmlformats.org/officeDocument/2006/relationships/image" Target="../media/image39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emf"/><Relationship Id="rId5" Type="http://schemas.openxmlformats.org/officeDocument/2006/relationships/image" Target="../media/image37.emf"/><Relationship Id="rId4" Type="http://schemas.openxmlformats.org/officeDocument/2006/relationships/image" Target="../media/image36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tiff"/><Relationship Id="rId13" Type="http://schemas.openxmlformats.org/officeDocument/2006/relationships/image" Target="../media/image50.tiff"/><Relationship Id="rId18" Type="http://schemas.openxmlformats.org/officeDocument/2006/relationships/image" Target="../media/image55.emf"/><Relationship Id="rId26" Type="http://schemas.openxmlformats.org/officeDocument/2006/relationships/image" Target="../media/image63.emf"/><Relationship Id="rId3" Type="http://schemas.openxmlformats.org/officeDocument/2006/relationships/image" Target="../media/image40.tiff"/><Relationship Id="rId21" Type="http://schemas.openxmlformats.org/officeDocument/2006/relationships/image" Target="../media/image58.emf"/><Relationship Id="rId7" Type="http://schemas.openxmlformats.org/officeDocument/2006/relationships/image" Target="../media/image44.tiff"/><Relationship Id="rId12" Type="http://schemas.openxmlformats.org/officeDocument/2006/relationships/image" Target="../media/image49.tiff"/><Relationship Id="rId17" Type="http://schemas.openxmlformats.org/officeDocument/2006/relationships/image" Target="../media/image54.emf"/><Relationship Id="rId25" Type="http://schemas.openxmlformats.org/officeDocument/2006/relationships/image" Target="../media/image62.emf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53.emf"/><Relationship Id="rId20" Type="http://schemas.openxmlformats.org/officeDocument/2006/relationships/image" Target="../media/image57.emf"/><Relationship Id="rId29" Type="http://schemas.openxmlformats.org/officeDocument/2006/relationships/image" Target="../media/image6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3.tiff"/><Relationship Id="rId11" Type="http://schemas.openxmlformats.org/officeDocument/2006/relationships/image" Target="../media/image48.tiff"/><Relationship Id="rId24" Type="http://schemas.openxmlformats.org/officeDocument/2006/relationships/image" Target="../media/image61.emf"/><Relationship Id="rId5" Type="http://schemas.openxmlformats.org/officeDocument/2006/relationships/image" Target="../media/image42.tiff"/><Relationship Id="rId15" Type="http://schemas.openxmlformats.org/officeDocument/2006/relationships/image" Target="../media/image52.emf"/><Relationship Id="rId23" Type="http://schemas.openxmlformats.org/officeDocument/2006/relationships/image" Target="../media/image60.emf"/><Relationship Id="rId28" Type="http://schemas.openxmlformats.org/officeDocument/2006/relationships/image" Target="../media/image65.emf"/><Relationship Id="rId10" Type="http://schemas.openxmlformats.org/officeDocument/2006/relationships/image" Target="../media/image47.tiff"/><Relationship Id="rId19" Type="http://schemas.openxmlformats.org/officeDocument/2006/relationships/image" Target="../media/image56.emf"/><Relationship Id="rId4" Type="http://schemas.openxmlformats.org/officeDocument/2006/relationships/image" Target="../media/image41.tiff"/><Relationship Id="rId9" Type="http://schemas.openxmlformats.org/officeDocument/2006/relationships/image" Target="../media/image46.tiff"/><Relationship Id="rId14" Type="http://schemas.openxmlformats.org/officeDocument/2006/relationships/image" Target="../media/image51.tiff"/><Relationship Id="rId22" Type="http://schemas.openxmlformats.org/officeDocument/2006/relationships/image" Target="../media/image59.emf"/><Relationship Id="rId27" Type="http://schemas.openxmlformats.org/officeDocument/2006/relationships/image" Target="../media/image64.emf"/><Relationship Id="rId30" Type="http://schemas.openxmlformats.org/officeDocument/2006/relationships/image" Target="../media/image67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3.emf"/><Relationship Id="rId13" Type="http://schemas.openxmlformats.org/officeDocument/2006/relationships/image" Target="../media/image78.emf"/><Relationship Id="rId3" Type="http://schemas.openxmlformats.org/officeDocument/2006/relationships/image" Target="../media/image68.png"/><Relationship Id="rId7" Type="http://schemas.openxmlformats.org/officeDocument/2006/relationships/image" Target="../media/image72.emf"/><Relationship Id="rId12" Type="http://schemas.openxmlformats.org/officeDocument/2006/relationships/image" Target="../media/image77.emf"/><Relationship Id="rId17" Type="http://schemas.openxmlformats.org/officeDocument/2006/relationships/image" Target="../media/image82.emf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8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1.emf"/><Relationship Id="rId11" Type="http://schemas.openxmlformats.org/officeDocument/2006/relationships/image" Target="../media/image76.emf"/><Relationship Id="rId5" Type="http://schemas.openxmlformats.org/officeDocument/2006/relationships/image" Target="../media/image70.emf"/><Relationship Id="rId15" Type="http://schemas.openxmlformats.org/officeDocument/2006/relationships/image" Target="../media/image80.emf"/><Relationship Id="rId10" Type="http://schemas.openxmlformats.org/officeDocument/2006/relationships/image" Target="../media/image75.emf"/><Relationship Id="rId4" Type="http://schemas.openxmlformats.org/officeDocument/2006/relationships/image" Target="../media/image69.emf"/><Relationship Id="rId9" Type="http://schemas.openxmlformats.org/officeDocument/2006/relationships/image" Target="../media/image74.emf"/><Relationship Id="rId14" Type="http://schemas.openxmlformats.org/officeDocument/2006/relationships/image" Target="../media/image79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88.emf"/><Relationship Id="rId3" Type="http://schemas.openxmlformats.org/officeDocument/2006/relationships/image" Target="../media/image83.emf"/><Relationship Id="rId7" Type="http://schemas.openxmlformats.org/officeDocument/2006/relationships/image" Target="../media/image87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6.emf"/><Relationship Id="rId5" Type="http://schemas.openxmlformats.org/officeDocument/2006/relationships/image" Target="../media/image85.emf"/><Relationship Id="rId4" Type="http://schemas.openxmlformats.org/officeDocument/2006/relationships/image" Target="../media/image84.emf"/><Relationship Id="rId9" Type="http://schemas.openxmlformats.org/officeDocument/2006/relationships/image" Target="../media/image89.emf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0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3" name="Object 52">
            <a:extLst>
              <a:ext uri="{FF2B5EF4-FFF2-40B4-BE49-F238E27FC236}">
                <a16:creationId xmlns:a16="http://schemas.microsoft.com/office/drawing/2014/main" id="{D998F19D-B2DA-FB7B-BC76-1694A4889C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520434"/>
              </p:ext>
            </p:extLst>
          </p:nvPr>
        </p:nvGraphicFramePr>
        <p:xfrm>
          <a:off x="511171" y="478669"/>
          <a:ext cx="2777316" cy="19823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782505" imgH="2698634" progId="Prism9.Document">
                  <p:embed/>
                </p:oleObj>
              </mc:Choice>
              <mc:Fallback>
                <p:oleObj name="Prism 9" r:id="rId3" imgW="3782505" imgH="2698634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88FA4005-0E5F-4B62-A2D3-4488F0D79A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11171" y="478669"/>
                        <a:ext cx="2777316" cy="19823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F421DD7B-2629-AB67-0996-275F24D13CD6}"/>
              </a:ext>
            </a:extLst>
          </p:cNvPr>
          <p:cNvSpPr txBox="1"/>
          <p:nvPr/>
        </p:nvSpPr>
        <p:spPr>
          <a:xfrm>
            <a:off x="717613" y="32364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3EB0B00-D6A1-E979-5235-AF6A317381D7}"/>
              </a:ext>
            </a:extLst>
          </p:cNvPr>
          <p:cNvSpPr txBox="1"/>
          <p:nvPr/>
        </p:nvSpPr>
        <p:spPr>
          <a:xfrm>
            <a:off x="717613" y="2483696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4E76D7C-5120-51B1-AC22-90977AF783AD}"/>
              </a:ext>
            </a:extLst>
          </p:cNvPr>
          <p:cNvSpPr txBox="1"/>
          <p:nvPr/>
        </p:nvSpPr>
        <p:spPr>
          <a:xfrm>
            <a:off x="3302269" y="405334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F41879D-CC89-665A-DE32-F12C0DA317E3}"/>
              </a:ext>
            </a:extLst>
          </p:cNvPr>
          <p:cNvSpPr txBox="1"/>
          <p:nvPr/>
        </p:nvSpPr>
        <p:spPr>
          <a:xfrm>
            <a:off x="1907026" y="248531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6C53CD0-7841-224C-97BE-A3C1D32155C4}"/>
              </a:ext>
            </a:extLst>
          </p:cNvPr>
          <p:cNvSpPr txBox="1"/>
          <p:nvPr/>
        </p:nvSpPr>
        <p:spPr>
          <a:xfrm>
            <a:off x="1152498" y="2561683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8 week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44D7E08-75D3-D4F0-881F-3D00D2C59EB3}"/>
              </a:ext>
            </a:extLst>
          </p:cNvPr>
          <p:cNvSpPr txBox="1"/>
          <p:nvPr/>
        </p:nvSpPr>
        <p:spPr>
          <a:xfrm>
            <a:off x="2170872" y="2549247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6 week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13712E-25B1-E528-611D-50BF3EC74E8D}"/>
              </a:ext>
            </a:extLst>
          </p:cNvPr>
          <p:cNvSpPr txBox="1"/>
          <p:nvPr/>
        </p:nvSpPr>
        <p:spPr>
          <a:xfrm>
            <a:off x="3111779" y="248769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D4CA7F5-2DE9-8F66-6DFF-F5D48D1E2C37}"/>
              </a:ext>
            </a:extLst>
          </p:cNvPr>
          <p:cNvSpPr txBox="1"/>
          <p:nvPr/>
        </p:nvSpPr>
        <p:spPr>
          <a:xfrm>
            <a:off x="4567686" y="248369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7603817-E3D3-C2D9-5BC9-0D9853842AAE}"/>
              </a:ext>
            </a:extLst>
          </p:cNvPr>
          <p:cNvSpPr txBox="1"/>
          <p:nvPr/>
        </p:nvSpPr>
        <p:spPr>
          <a:xfrm>
            <a:off x="717613" y="415358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C867C39-BDFE-1DD8-098F-B3F66ECDEBB7}"/>
              </a:ext>
            </a:extLst>
          </p:cNvPr>
          <p:cNvSpPr txBox="1"/>
          <p:nvPr/>
        </p:nvSpPr>
        <p:spPr>
          <a:xfrm>
            <a:off x="2416961" y="419170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88110F5-FB36-B1F1-47FC-E961AFA4B21D}"/>
              </a:ext>
            </a:extLst>
          </p:cNvPr>
          <p:cNvSpPr txBox="1"/>
          <p:nvPr/>
        </p:nvSpPr>
        <p:spPr>
          <a:xfrm>
            <a:off x="4377887" y="4191702"/>
            <a:ext cx="3481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18FBCA1-2752-E5EB-9B54-E98164C79163}"/>
              </a:ext>
            </a:extLst>
          </p:cNvPr>
          <p:cNvSpPr txBox="1"/>
          <p:nvPr/>
        </p:nvSpPr>
        <p:spPr>
          <a:xfrm>
            <a:off x="717613" y="5804254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CA0492F-643A-2CB3-7C21-5D492B9410CF}"/>
              </a:ext>
            </a:extLst>
          </p:cNvPr>
          <p:cNvSpPr txBox="1"/>
          <p:nvPr/>
        </p:nvSpPr>
        <p:spPr>
          <a:xfrm>
            <a:off x="2416957" y="582456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2A17C97-4A2E-6DBA-6584-BA18E6811760}"/>
              </a:ext>
            </a:extLst>
          </p:cNvPr>
          <p:cNvSpPr txBox="1"/>
          <p:nvPr/>
        </p:nvSpPr>
        <p:spPr>
          <a:xfrm>
            <a:off x="4286129" y="5824562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4B888C8-8BDA-7825-0E19-D55B6FDA7871}"/>
              </a:ext>
            </a:extLst>
          </p:cNvPr>
          <p:cNvSpPr txBox="1"/>
          <p:nvPr/>
        </p:nvSpPr>
        <p:spPr>
          <a:xfrm>
            <a:off x="270641" y="7659707"/>
            <a:ext cx="73152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Increases in body weight, visceral adipose tissue mass, and leukocyte counts within spleen, liver, WAT, 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mentum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d MAT of HFD-fed WT female mice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ight gain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,B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r final body weight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D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f WT female mice starting NCD or HFD-diet at 8 or 16 weeks-of-age. Mass of w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te adipose tissue (WAT)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mental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and mesenteric adipose tissue (MAT)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from aged-matched NCD and HFD mice. Absolute numbers of leukocytes from spleen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liver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WAT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mentum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and MAT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from age-matched NCD and HFD mice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ta from 2-6 independent experiments for each age group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n=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-5 mice/grp. Mean ± SEM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[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’s t-test (two-tailed) (C-L)]; *p &lt; 0.05, **p &lt; 0.01, ****p &lt; 0.0001.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F159914A-66F0-A793-3AD2-58499B38995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98022" y="2721349"/>
            <a:ext cx="1654722" cy="1438889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DB67437B-C40B-128F-95DC-FF0C98B32D8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44815" y="4304298"/>
            <a:ext cx="1658928" cy="1506659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DC56D31D-74B7-A023-4FD6-FEEF52EB8F4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75564" y="4284370"/>
            <a:ext cx="1686819" cy="1519728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039C9324-30F8-5B26-FF0A-06312B8FB48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675879" y="5997423"/>
            <a:ext cx="1706352" cy="1480985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C5208117-B026-5D14-DF45-D398C57A97B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01486" y="5994056"/>
            <a:ext cx="1634976" cy="1496157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365104D9-7E7C-3DB1-38DE-37F936FAE5E7}"/>
              </a:ext>
            </a:extLst>
          </p:cNvPr>
          <p:cNvGrpSpPr/>
          <p:nvPr/>
        </p:nvGrpSpPr>
        <p:grpSpPr>
          <a:xfrm>
            <a:off x="5476095" y="2237728"/>
            <a:ext cx="660367" cy="452610"/>
            <a:chOff x="6252744" y="5879783"/>
            <a:chExt cx="660367" cy="452610"/>
          </a:xfrm>
        </p:grpSpPr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3032D995-FBEA-E2EF-27C8-16C1291086E1}"/>
                </a:ext>
              </a:extLst>
            </p:cNvPr>
            <p:cNvSpPr/>
            <p:nvPr/>
          </p:nvSpPr>
          <p:spPr>
            <a:xfrm>
              <a:off x="6252744" y="5956105"/>
              <a:ext cx="216846" cy="124356"/>
            </a:xfrm>
            <a:prstGeom prst="rect">
              <a:avLst/>
            </a:prstGeom>
            <a:solidFill>
              <a:srgbClr val="92929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EAEECC45-1D65-7A50-3341-5809C9CCCF6F}"/>
                </a:ext>
              </a:extLst>
            </p:cNvPr>
            <p:cNvSpPr/>
            <p:nvPr/>
          </p:nvSpPr>
          <p:spPr>
            <a:xfrm>
              <a:off x="6252744" y="6125801"/>
              <a:ext cx="216846" cy="124356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E61FEC2E-A50D-6C0E-11F4-DF989E27F71C}"/>
                </a:ext>
              </a:extLst>
            </p:cNvPr>
            <p:cNvSpPr txBox="1"/>
            <p:nvPr/>
          </p:nvSpPr>
          <p:spPr>
            <a:xfrm>
              <a:off x="6407844" y="5879783"/>
              <a:ext cx="5052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CD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1CEB46C-054E-3619-5D5A-9FE16C77D36F}"/>
                </a:ext>
              </a:extLst>
            </p:cNvPr>
            <p:cNvSpPr txBox="1"/>
            <p:nvPr/>
          </p:nvSpPr>
          <p:spPr>
            <a:xfrm>
              <a:off x="6420668" y="6055394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FD</a:t>
              </a:r>
            </a:p>
          </p:txBody>
        </p:sp>
      </p:grpSp>
      <p:graphicFrame>
        <p:nvGraphicFramePr>
          <p:cNvPr id="54" name="Object 53">
            <a:extLst>
              <a:ext uri="{FF2B5EF4-FFF2-40B4-BE49-F238E27FC236}">
                <a16:creationId xmlns:a16="http://schemas.microsoft.com/office/drawing/2014/main" id="{4B178D0C-EBBC-0241-4478-75AA8F8B19A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7049177"/>
              </p:ext>
            </p:extLst>
          </p:nvPr>
        </p:nvGraphicFramePr>
        <p:xfrm>
          <a:off x="3449905" y="514199"/>
          <a:ext cx="2777316" cy="1928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3782505" imgH="2698634" progId="Prism9.Document">
                  <p:embed/>
                </p:oleObj>
              </mc:Choice>
              <mc:Fallback>
                <p:oleObj name="Prism 9" r:id="rId10" imgW="3782505" imgH="2698634" progId="Prism9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4CDF16F9-8781-C3B9-7471-5C05F65AE4F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449905" y="514199"/>
                        <a:ext cx="2777316" cy="1928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6" name="Rectangle 55">
            <a:extLst>
              <a:ext uri="{FF2B5EF4-FFF2-40B4-BE49-F238E27FC236}">
                <a16:creationId xmlns:a16="http://schemas.microsoft.com/office/drawing/2014/main" id="{868CD33F-ABFA-FBC3-D4F5-58F62BDB3E7B}"/>
              </a:ext>
            </a:extLst>
          </p:cNvPr>
          <p:cNvSpPr/>
          <p:nvPr/>
        </p:nvSpPr>
        <p:spPr>
          <a:xfrm>
            <a:off x="1788340" y="2225310"/>
            <a:ext cx="3394684" cy="21435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E2411C3-5D80-287E-1602-02834E40DE78}"/>
              </a:ext>
            </a:extLst>
          </p:cNvPr>
          <p:cNvSpPr txBox="1"/>
          <p:nvPr/>
        </p:nvSpPr>
        <p:spPr>
          <a:xfrm>
            <a:off x="1471643" y="2165668"/>
            <a:ext cx="9893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Days on Diet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430E435-B58D-04D1-001E-3E19686D7B65}"/>
              </a:ext>
            </a:extLst>
          </p:cNvPr>
          <p:cNvSpPr txBox="1"/>
          <p:nvPr/>
        </p:nvSpPr>
        <p:spPr>
          <a:xfrm>
            <a:off x="4329601" y="2171884"/>
            <a:ext cx="9893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Days on Diet</a:t>
            </a:r>
          </a:p>
        </p:txBody>
      </p:sp>
      <p:pic>
        <p:nvPicPr>
          <p:cNvPr id="61" name="Picture 60" descr="A close-up of a symbol&#10;&#10;Description automatically generated">
            <a:extLst>
              <a:ext uri="{FF2B5EF4-FFF2-40B4-BE49-F238E27FC236}">
                <a16:creationId xmlns:a16="http://schemas.microsoft.com/office/drawing/2014/main" id="{B6CAEFE9-D3C0-EBC8-E0D4-DFD6B25DF96D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685442" y="661559"/>
            <a:ext cx="739243" cy="473447"/>
          </a:xfrm>
          <a:prstGeom prst="rect">
            <a:avLst/>
          </a:prstGeom>
        </p:spPr>
      </p:pic>
      <p:sp>
        <p:nvSpPr>
          <p:cNvPr id="62" name="Rectangle 61">
            <a:extLst>
              <a:ext uri="{FF2B5EF4-FFF2-40B4-BE49-F238E27FC236}">
                <a16:creationId xmlns:a16="http://schemas.microsoft.com/office/drawing/2014/main" id="{AF85167D-4381-D47B-9ACC-6E9C133A2463}"/>
              </a:ext>
            </a:extLst>
          </p:cNvPr>
          <p:cNvSpPr/>
          <p:nvPr/>
        </p:nvSpPr>
        <p:spPr>
          <a:xfrm>
            <a:off x="1041621" y="715617"/>
            <a:ext cx="615577" cy="4214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E4497E35-07C2-624F-F674-BF9E274A409F}"/>
              </a:ext>
            </a:extLst>
          </p:cNvPr>
          <p:cNvSpPr/>
          <p:nvPr/>
        </p:nvSpPr>
        <p:spPr>
          <a:xfrm>
            <a:off x="3928241" y="708329"/>
            <a:ext cx="615577" cy="4214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964782B-A693-9AD0-0D75-54194083F188}"/>
              </a:ext>
            </a:extLst>
          </p:cNvPr>
          <p:cNvSpPr txBox="1"/>
          <p:nvPr/>
        </p:nvSpPr>
        <p:spPr>
          <a:xfrm>
            <a:off x="1155558" y="593947"/>
            <a:ext cx="15648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Diet start: 8 weeks of age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89A9E61-145F-71A8-2969-6F54A524ED1A}"/>
              </a:ext>
            </a:extLst>
          </p:cNvPr>
          <p:cNvSpPr txBox="1"/>
          <p:nvPr/>
        </p:nvSpPr>
        <p:spPr>
          <a:xfrm>
            <a:off x="4007396" y="588438"/>
            <a:ext cx="1633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Diet start: 16 weeks of age</a:t>
            </a:r>
          </a:p>
        </p:txBody>
      </p:sp>
      <p:graphicFrame>
        <p:nvGraphicFramePr>
          <p:cNvPr id="64" name="Object 63">
            <a:extLst>
              <a:ext uri="{FF2B5EF4-FFF2-40B4-BE49-F238E27FC236}">
                <a16:creationId xmlns:a16="http://schemas.microsoft.com/office/drawing/2014/main" id="{1743BE17-6D16-2FB1-4B71-D9977724ABF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1222602"/>
              </p:ext>
            </p:extLst>
          </p:nvPr>
        </p:nvGraphicFramePr>
        <p:xfrm>
          <a:off x="787931" y="2739892"/>
          <a:ext cx="1341437" cy="1590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3" imgW="2276058" imgH="2698634" progId="Prism9.Document">
                  <p:embed/>
                </p:oleObj>
              </mc:Choice>
              <mc:Fallback>
                <p:oleObj name="Prism 9" r:id="rId13" imgW="2276058" imgH="2698634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4AF40557-6E9E-ADDF-3D84-8FB1C5CA7D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787931" y="2739892"/>
                        <a:ext cx="1341437" cy="1590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" name="Object 64">
            <a:extLst>
              <a:ext uri="{FF2B5EF4-FFF2-40B4-BE49-F238E27FC236}">
                <a16:creationId xmlns:a16="http://schemas.microsoft.com/office/drawing/2014/main" id="{A87B2A11-38AC-DA81-C8C3-BC38347325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7733451"/>
              </p:ext>
            </p:extLst>
          </p:nvPr>
        </p:nvGraphicFramePr>
        <p:xfrm>
          <a:off x="1920218" y="2669978"/>
          <a:ext cx="1309590" cy="1636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5" imgW="2276058" imgH="2841976" progId="Prism9.Document">
                  <p:embed/>
                </p:oleObj>
              </mc:Choice>
              <mc:Fallback>
                <p:oleObj name="Prism 9" r:id="rId15" imgW="2276058" imgH="2841976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1766FA9F-860A-6D0C-A94A-47BE74E8082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920218" y="2669978"/>
                        <a:ext cx="1309590" cy="1636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6" name="Picture 65">
            <a:extLst>
              <a:ext uri="{FF2B5EF4-FFF2-40B4-BE49-F238E27FC236}">
                <a16:creationId xmlns:a16="http://schemas.microsoft.com/office/drawing/2014/main" id="{2C8F82D6-9999-E02E-1DD5-EBC28E025692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996277" y="2713651"/>
            <a:ext cx="1641897" cy="1427737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530A6FBC-2780-4EFC-4ACF-E7B8989FED28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638242" y="4330567"/>
            <a:ext cx="1742722" cy="1458840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8894ED52-FB04-C35A-5509-B4BF206FBEB9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717613" y="6048298"/>
            <a:ext cx="1787227" cy="14652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82696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A3C2594-D58F-D0B8-0DAE-02B113F67A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9971" y="928915"/>
            <a:ext cx="1371598" cy="152399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8CBC299-9839-8D10-673B-A68BE1CC5A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0743" y="2467430"/>
            <a:ext cx="1409698" cy="152399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859B4FDA-4DB4-8369-11D1-133DA6F6E4D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78690" y="928915"/>
            <a:ext cx="1424938" cy="152399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33744DD-D0A7-A55B-3D92-60EB3053BAD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10500" y="2330270"/>
            <a:ext cx="1409698" cy="166115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8EE23F3-8FC4-7EE4-2CB0-5843C2C3860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00401" y="928915"/>
            <a:ext cx="1371598" cy="152399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DB9FF71-1F69-5506-2122-11025F85BF5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01042" y="2467429"/>
            <a:ext cx="1402078" cy="152399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D351502-F3D7-D16B-8001-8418249034C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420705" y="928915"/>
            <a:ext cx="1371598" cy="152399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0B9FE97-30AB-6A6F-851F-0A88A7A3297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431930" y="2467428"/>
            <a:ext cx="1409698" cy="152399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58738B2-8392-50F9-C942-72E1ED0767E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722967" y="928914"/>
            <a:ext cx="1325878" cy="152399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B0DAD7F-729A-D76C-60E1-F329CD1AF31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728261" y="2467427"/>
            <a:ext cx="1434788" cy="152399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C4E4DB32-46BC-5D4C-DAC5-E53BD2D3001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10593" y="4673599"/>
            <a:ext cx="1280975" cy="143753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0CF93C3-DB31-9232-7A66-A072CE9B621F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40743" y="6034552"/>
            <a:ext cx="1316557" cy="1494471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5A510CE7-151B-3E29-1C49-06101E68EB8C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991568" y="4673599"/>
            <a:ext cx="1338023" cy="143104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C49C7DD-0815-B81E-FAE2-996FE08C8CCE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957300" y="6097982"/>
            <a:ext cx="1323713" cy="1431041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71A734DE-1701-C567-F23A-6606B47E25C6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242232" y="4673599"/>
            <a:ext cx="1287936" cy="143104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C837C0C2-99D4-9BBB-2DC9-116FD1B6E173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200401" y="6091484"/>
            <a:ext cx="1316557" cy="143104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0CD0F081-5B78-4F0E-4FA8-FF2D0C32D27A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442811" y="4648295"/>
            <a:ext cx="1316557" cy="146284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3BEDB9B5-2EB8-374E-41AF-12B9936D7CD3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420706" y="6034552"/>
            <a:ext cx="1376374" cy="1487972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721F7688-3BD0-89F8-8F7A-244757C53050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717537" y="6028053"/>
            <a:ext cx="1340629" cy="1494471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45046C31-FE0F-F3FB-A4E5-4079FF545E41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728466" y="4563232"/>
            <a:ext cx="1333342" cy="1547903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BAD93C8-6BB8-CB3A-2EE7-CEFBEAD67E7D}"/>
              </a:ext>
            </a:extLst>
          </p:cNvPr>
          <p:cNvSpPr txBox="1"/>
          <p:nvPr/>
        </p:nvSpPr>
        <p:spPr>
          <a:xfrm>
            <a:off x="570380" y="581458"/>
            <a:ext cx="14285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et Start: 8 week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B045D7A-F459-1B54-3849-9EAE5F915DCF}"/>
              </a:ext>
            </a:extLst>
          </p:cNvPr>
          <p:cNvSpPr txBox="1"/>
          <p:nvPr/>
        </p:nvSpPr>
        <p:spPr>
          <a:xfrm>
            <a:off x="657120" y="4371296"/>
            <a:ext cx="1505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et Start: 16 week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34DBDF8-365F-6584-C306-58414D1F6547}"/>
              </a:ext>
            </a:extLst>
          </p:cNvPr>
          <p:cNvSpPr txBox="1"/>
          <p:nvPr/>
        </p:nvSpPr>
        <p:spPr>
          <a:xfrm>
            <a:off x="228600" y="7535521"/>
            <a:ext cx="73152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Characterization of the splenic B cell compartment of female WT mice started on NCD and HFD at 8 or 16 weeks of ag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J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low cytometry of NCD and HFD WT female mice started on the diet at 8 weeks of age reveals frequencies and numbers of total splenic B cell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splenic follicular B cell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,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splenic marginal zone B cell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,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splenic age associated B cells (ABCs)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,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splenic T-bet+ CD11c+ B cell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,J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-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low cytometry of NCD and HFD WT female mice started on the diet at 16 weeks of age reveals frequencies and numbers of total splenic B cell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,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splenic follicular B cell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,Q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splenic marginal zone B cell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,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splenic age associated B cells (ABCs)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,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splenic T-bet+ CD11c+ B cell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,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Pool of three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J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four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-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dependent experiments. n=4-5 mice/grp, 16-25 week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J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29-30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-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eks old. Bars indicate mean ± SEM. Each symbol indicates an individual mouse. [Non-parametric Unpaired two-tailed t-test] *p ≤ 0.05, **p ≤ 0.01, ***p ≤ 0.001, ****p ≤ 0.0001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F457A94-E160-9AD4-8266-447AC61AAE01}"/>
              </a:ext>
            </a:extLst>
          </p:cNvPr>
          <p:cNvSpPr txBox="1"/>
          <p:nvPr/>
        </p:nvSpPr>
        <p:spPr>
          <a:xfrm>
            <a:off x="570380" y="854262"/>
            <a:ext cx="54292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                              B                                C                               D                              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BD9ACDA-32A6-DA1C-8D19-984EF9C1D57F}"/>
              </a:ext>
            </a:extLst>
          </p:cNvPr>
          <p:cNvSpPr txBox="1"/>
          <p:nvPr/>
        </p:nvSpPr>
        <p:spPr>
          <a:xfrm>
            <a:off x="619971" y="2321669"/>
            <a:ext cx="54104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                              G                                H                               I                                J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1A47069-B3DF-6990-EDC7-4648E8BE914E}"/>
              </a:ext>
            </a:extLst>
          </p:cNvPr>
          <p:cNvSpPr txBox="1"/>
          <p:nvPr/>
        </p:nvSpPr>
        <p:spPr>
          <a:xfrm>
            <a:off x="610609" y="4522448"/>
            <a:ext cx="54736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                                L                               M                             N                               O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5C22D5F-FF32-B0F2-CA92-DCE7D0070687}"/>
              </a:ext>
            </a:extLst>
          </p:cNvPr>
          <p:cNvSpPr txBox="1"/>
          <p:nvPr/>
        </p:nvSpPr>
        <p:spPr>
          <a:xfrm>
            <a:off x="574894" y="5868077"/>
            <a:ext cx="553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                                 Q                                R                             S                                T</a:t>
            </a:r>
          </a:p>
        </p:txBody>
      </p:sp>
    </p:spTree>
    <p:extLst>
      <p:ext uri="{BB962C8B-B14F-4D97-AF65-F5344CB8AC3E}">
        <p14:creationId xmlns:p14="http://schemas.microsoft.com/office/powerpoint/2010/main" val="2521107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24A5CD0-49AD-8C25-A2D3-BF300D975C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7718" y="234247"/>
            <a:ext cx="6176963" cy="479495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9B6A537-6E34-D2E8-71C3-735777EB9E1D}"/>
              </a:ext>
            </a:extLst>
          </p:cNvPr>
          <p:cNvSpPr txBox="1"/>
          <p:nvPr/>
        </p:nvSpPr>
        <p:spPr>
          <a:xfrm>
            <a:off x="228599" y="4918341"/>
            <a:ext cx="73152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 vitro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ulture of splenic B cells with increasing concentrations of free fatty acids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low cytometry summary of total splenic B cell viability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r percentages and absolute numbers of T-bet+ CD11c+ splenic B cells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from NCD WT female mice stimulate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vitro </a:t>
            </a:r>
            <a:r>
              <a:rPr lang="en-US" sz="1200" dirty="0">
                <a:effectLst/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with anti-CD40, R848, IL-21,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IFNγ</a:t>
            </a:r>
            <a:r>
              <a:rPr lang="en-US" sz="1200" dirty="0">
                <a:effectLst/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for 3 days with different concentrations of Oleate (OA), Palmitate (PA), or control BSA as noted. 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P</a:t>
            </a:r>
            <a:r>
              <a:rPr lang="en-US" sz="1200" dirty="0">
                <a:effectLst/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ool of two independent experiments. n=3 mice/grp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.</a:t>
            </a:r>
            <a:r>
              <a:rPr lang="en-US" sz="1200" dirty="0">
                <a:effectLst/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Bars indicate mean ± SEM. Each symbol indicates an individual mouse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. [Two-way ANOVA] </a:t>
            </a:r>
            <a:r>
              <a:rPr lang="en-US" sz="1200" dirty="0">
                <a:effectLst/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*p ≤ 0.05, **p ≤ 0.01, ***p ≤ 0.001, ****p ≤ 0.0001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27992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27EFC3A-1C23-8364-DC50-9FB485C785C6}"/>
              </a:ext>
            </a:extLst>
          </p:cNvPr>
          <p:cNvSpPr txBox="1"/>
          <p:nvPr/>
        </p:nvSpPr>
        <p:spPr>
          <a:xfrm>
            <a:off x="250994" y="7140737"/>
            <a:ext cx="731520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 Characterization of adipose T-bet+ CD11c+ B cells in NCD and HFD mice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rcentages and numbers/gram of tissue of B cells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,B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T-bet+ CD11c+ B cells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,D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in white adipose tissue from NCD and HFD-fed mice. Representative flow cytometry plots of IgM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gD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in T-bet- CD11c- (T-be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T-bet+ CD11c+ (T-bet+,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 adipose B cells. Summary in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Flow cytometry detection CD86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MHC-II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Ki-67+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CXCR3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CXCR4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CXCR5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and CD36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in T-bet+ CD11c+ (T-bet+) and T-bet- CD11c- (T-bet-) adipose B cells.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Flow cytometry detection of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pidTO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FI, a surrogate measure of intracellular neutral lipid content, in T-bet+ CD11c+ (T-bet+) and T-bet- CD11c- (T-bet-) adipose B cells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ol of 7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D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4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-G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2-3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-J,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or 1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M,O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independent experiments. n=4-5 mice/grp. Bars indicate mean ± SEM. Each symbol indicates an individual mouse. Two data points were excluded based on ROUT</a:t>
            </a:r>
            <a:r>
              <a:rPr lang="en-US" sz="1200" dirty="0">
                <a:effectLst/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test (Q = 0.1</a:t>
            </a:r>
            <a:r>
              <a:rPr lang="en-US" sz="12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%) [Non-parametric Unpaired two-tailed t-test, Two-way ANOVA] *</a:t>
            </a:r>
            <a:r>
              <a:rPr lang="en-US" sz="1200" dirty="0">
                <a:effectLst/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p ≤ 0.05, **p ≤ 0.01, ***p ≤ 0.001, ****p ≤ 0.0001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20EA8A2D-1353-4903-E2B0-A05C8E73AB9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" t="32853" r="-13178" b="-516"/>
          <a:stretch/>
        </p:blipFill>
        <p:spPr>
          <a:xfrm>
            <a:off x="819466" y="1846257"/>
            <a:ext cx="5907597" cy="5440680"/>
          </a:xfrm>
          <a:prstGeom prst="rect">
            <a:avLst/>
          </a:prstGeom>
        </p:spPr>
      </p:pic>
      <p:grpSp>
        <p:nvGrpSpPr>
          <p:cNvPr id="13" name="Group 12">
            <a:extLst>
              <a:ext uri="{FF2B5EF4-FFF2-40B4-BE49-F238E27FC236}">
                <a16:creationId xmlns:a16="http://schemas.microsoft.com/office/drawing/2014/main" id="{5940993B-F3E3-46E6-21ED-9F5487B0C34C}"/>
              </a:ext>
            </a:extLst>
          </p:cNvPr>
          <p:cNvGrpSpPr/>
          <p:nvPr/>
        </p:nvGrpSpPr>
        <p:grpSpPr>
          <a:xfrm>
            <a:off x="802256" y="466940"/>
            <a:ext cx="4583616" cy="1509749"/>
            <a:chOff x="328930" y="239520"/>
            <a:chExt cx="4583616" cy="1509749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5B5A557-A07D-90FA-4C12-5D6871457B1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28930" y="303531"/>
              <a:ext cx="1289057" cy="1445738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BAC57F38-98BA-4796-66D0-38608B154B5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412749" y="303530"/>
              <a:ext cx="1344538" cy="1445739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B3DE5849-AEEF-4DC5-D4C5-66F9A65FD66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515635" y="321818"/>
              <a:ext cx="1230529" cy="1398329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F8DAFB45-3F86-90A9-9542-5F87E688D74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607491" y="358395"/>
              <a:ext cx="1305055" cy="1352388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36E15463-3EC5-8474-6808-736E1546C954}"/>
                </a:ext>
              </a:extLst>
            </p:cNvPr>
            <p:cNvSpPr txBox="1"/>
            <p:nvPr/>
          </p:nvSpPr>
          <p:spPr>
            <a:xfrm>
              <a:off x="329838" y="239520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4508DE6-393C-83EB-36E4-9A8B2802B596}"/>
                </a:ext>
              </a:extLst>
            </p:cNvPr>
            <p:cNvSpPr txBox="1"/>
            <p:nvPr/>
          </p:nvSpPr>
          <p:spPr>
            <a:xfrm>
              <a:off x="1372718" y="239521"/>
              <a:ext cx="304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65F303B-06A4-9731-058B-694F44077BE9}"/>
                </a:ext>
              </a:extLst>
            </p:cNvPr>
            <p:cNvSpPr txBox="1"/>
            <p:nvPr/>
          </p:nvSpPr>
          <p:spPr>
            <a:xfrm>
              <a:off x="2515635" y="256465"/>
              <a:ext cx="3097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3E75D86-852B-9CE8-F4B2-A636E9087312}"/>
                </a:ext>
              </a:extLst>
            </p:cNvPr>
            <p:cNvSpPr txBox="1"/>
            <p:nvPr/>
          </p:nvSpPr>
          <p:spPr>
            <a:xfrm>
              <a:off x="3435268" y="265610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149523E8-D773-F9B1-65AB-17C4F884DE2F}"/>
              </a:ext>
            </a:extLst>
          </p:cNvPr>
          <p:cNvSpPr txBox="1"/>
          <p:nvPr/>
        </p:nvSpPr>
        <p:spPr>
          <a:xfrm>
            <a:off x="879510" y="1777179"/>
            <a:ext cx="29367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00D9C11-461A-65F9-0EB2-B246AA50CA6E}"/>
              </a:ext>
            </a:extLst>
          </p:cNvPr>
          <p:cNvSpPr txBox="1"/>
          <p:nvPr/>
        </p:nvSpPr>
        <p:spPr>
          <a:xfrm>
            <a:off x="2228856" y="1777180"/>
            <a:ext cx="284052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82A6E7A-B355-1BAB-69A0-9EAF0B3A298B}"/>
              </a:ext>
            </a:extLst>
          </p:cNvPr>
          <p:cNvSpPr txBox="1"/>
          <p:nvPr/>
        </p:nvSpPr>
        <p:spPr>
          <a:xfrm>
            <a:off x="3624542" y="1794012"/>
            <a:ext cx="31451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6685168-1E36-1B29-CBED-CA0C05B6EE41}"/>
              </a:ext>
            </a:extLst>
          </p:cNvPr>
          <p:cNvSpPr txBox="1"/>
          <p:nvPr/>
        </p:nvSpPr>
        <p:spPr>
          <a:xfrm>
            <a:off x="879510" y="3343191"/>
            <a:ext cx="31451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1F6BD88-8C4C-CF09-7623-D27A8B4560D3}"/>
              </a:ext>
            </a:extLst>
          </p:cNvPr>
          <p:cNvSpPr txBox="1"/>
          <p:nvPr/>
        </p:nvSpPr>
        <p:spPr>
          <a:xfrm>
            <a:off x="2233088" y="3343191"/>
            <a:ext cx="243978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2432ED2-89CE-CEE6-C528-CD66325FDD44}"/>
              </a:ext>
            </a:extLst>
          </p:cNvPr>
          <p:cNvSpPr txBox="1"/>
          <p:nvPr/>
        </p:nvSpPr>
        <p:spPr>
          <a:xfrm>
            <a:off x="4062643" y="3343191"/>
            <a:ext cx="255198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730A229-8AF5-EBEB-173E-05B787687043}"/>
              </a:ext>
            </a:extLst>
          </p:cNvPr>
          <p:cNvSpPr txBox="1"/>
          <p:nvPr/>
        </p:nvSpPr>
        <p:spPr>
          <a:xfrm>
            <a:off x="819466" y="4573939"/>
            <a:ext cx="31451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87FAF60-F719-D1B7-CED0-EDCC3C9475E9}"/>
              </a:ext>
            </a:extLst>
          </p:cNvPr>
          <p:cNvSpPr txBox="1"/>
          <p:nvPr/>
        </p:nvSpPr>
        <p:spPr>
          <a:xfrm>
            <a:off x="2327190" y="4566597"/>
            <a:ext cx="29367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7968445-EF66-4EF3-000B-5F19C9A55FDB}"/>
              </a:ext>
            </a:extLst>
          </p:cNvPr>
          <p:cNvSpPr txBox="1"/>
          <p:nvPr/>
        </p:nvSpPr>
        <p:spPr>
          <a:xfrm>
            <a:off x="4062643" y="4575306"/>
            <a:ext cx="344966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DA310EC-223F-C42F-B1EF-AB38957B1EC6}"/>
              </a:ext>
            </a:extLst>
          </p:cNvPr>
          <p:cNvSpPr txBox="1"/>
          <p:nvPr/>
        </p:nvSpPr>
        <p:spPr>
          <a:xfrm>
            <a:off x="879510" y="5837482"/>
            <a:ext cx="31451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D96800F-EDCB-3511-0E90-DC620AE5ED6B}"/>
              </a:ext>
            </a:extLst>
          </p:cNvPr>
          <p:cNvSpPr txBox="1"/>
          <p:nvPr/>
        </p:nvSpPr>
        <p:spPr>
          <a:xfrm>
            <a:off x="2327190" y="5837481"/>
            <a:ext cx="316112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</a:p>
        </p:txBody>
      </p:sp>
    </p:spTree>
    <p:extLst>
      <p:ext uri="{BB962C8B-B14F-4D97-AF65-F5344CB8AC3E}">
        <p14:creationId xmlns:p14="http://schemas.microsoft.com/office/powerpoint/2010/main" val="5020179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5" name="Picture 104">
            <a:extLst>
              <a:ext uri="{FF2B5EF4-FFF2-40B4-BE49-F238E27FC236}">
                <a16:creationId xmlns:a16="http://schemas.microsoft.com/office/drawing/2014/main" id="{F28F4BBC-5E0C-28EC-B06E-8CA0348E8D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0710" y="3331065"/>
            <a:ext cx="1049869" cy="1022058"/>
          </a:xfrm>
          <a:prstGeom prst="rect">
            <a:avLst/>
          </a:prstGeom>
        </p:spPr>
      </p:pic>
      <p:pic>
        <p:nvPicPr>
          <p:cNvPr id="106" name="Picture 105">
            <a:extLst>
              <a:ext uri="{FF2B5EF4-FFF2-40B4-BE49-F238E27FC236}">
                <a16:creationId xmlns:a16="http://schemas.microsoft.com/office/drawing/2014/main" id="{2BD312F4-9D40-C9FA-0088-DB7697E9961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81286" y="3331065"/>
            <a:ext cx="1049869" cy="1022058"/>
          </a:xfrm>
          <a:prstGeom prst="rect">
            <a:avLst/>
          </a:prstGeom>
        </p:spPr>
      </p:pic>
      <p:pic>
        <p:nvPicPr>
          <p:cNvPr id="95" name="Picture 94">
            <a:extLst>
              <a:ext uri="{FF2B5EF4-FFF2-40B4-BE49-F238E27FC236}">
                <a16:creationId xmlns:a16="http://schemas.microsoft.com/office/drawing/2014/main" id="{845A4031-E4CB-65AA-FF0F-8559493E6AB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30293" y="964064"/>
            <a:ext cx="1038177" cy="1010676"/>
          </a:xfrm>
          <a:prstGeom prst="rect">
            <a:avLst/>
          </a:prstGeom>
        </p:spPr>
      </p:pic>
      <p:pic>
        <p:nvPicPr>
          <p:cNvPr id="97" name="Picture 96">
            <a:extLst>
              <a:ext uri="{FF2B5EF4-FFF2-40B4-BE49-F238E27FC236}">
                <a16:creationId xmlns:a16="http://schemas.microsoft.com/office/drawing/2014/main" id="{EE9F8FFD-10C4-8E80-DB8D-90208601E81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34891" y="974796"/>
            <a:ext cx="1037557" cy="1010072"/>
          </a:xfrm>
          <a:prstGeom prst="rect">
            <a:avLst/>
          </a:prstGeom>
        </p:spPr>
      </p:pic>
      <p:pic>
        <p:nvPicPr>
          <p:cNvPr id="98" name="Picture 97">
            <a:extLst>
              <a:ext uri="{FF2B5EF4-FFF2-40B4-BE49-F238E27FC236}">
                <a16:creationId xmlns:a16="http://schemas.microsoft.com/office/drawing/2014/main" id="{313F2469-A290-690B-AD5A-F9683B60F9D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7110" y="2162245"/>
            <a:ext cx="1037339" cy="1009860"/>
          </a:xfrm>
          <a:prstGeom prst="rect">
            <a:avLst/>
          </a:prstGeom>
        </p:spPr>
      </p:pic>
      <p:pic>
        <p:nvPicPr>
          <p:cNvPr id="99" name="Picture 98">
            <a:extLst>
              <a:ext uri="{FF2B5EF4-FFF2-40B4-BE49-F238E27FC236}">
                <a16:creationId xmlns:a16="http://schemas.microsoft.com/office/drawing/2014/main" id="{C3164AF1-67DB-D82C-5839-18712D42A4A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42266" y="2162245"/>
            <a:ext cx="1037339" cy="100986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03B5CFF3-139C-1B67-4018-4D5FD0604DE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62428" y="5281163"/>
            <a:ext cx="1037936" cy="101007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0255EE05-1875-096E-C3B1-EBD3404563E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900364" y="5281163"/>
            <a:ext cx="1037936" cy="101007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B3B51EB-B86C-1E5B-F70A-C1389E4A1D5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62428" y="6488766"/>
            <a:ext cx="1037936" cy="1010072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AB594C65-2822-9324-B392-7D47CF6627E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900364" y="6488766"/>
            <a:ext cx="1037936" cy="1010072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D9B9324C-9A0B-932B-D52D-58532FD7208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62428" y="7694716"/>
            <a:ext cx="1037936" cy="1010441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AF5760DF-D5BA-1284-8320-9E51446DA21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900364" y="7694716"/>
            <a:ext cx="1037936" cy="1010441"/>
          </a:xfrm>
          <a:prstGeom prst="rect">
            <a:avLst/>
          </a:prstGeom>
        </p:spPr>
      </p:pic>
      <p:sp>
        <p:nvSpPr>
          <p:cNvPr id="21" name="Left-Up Arrow 20">
            <a:extLst>
              <a:ext uri="{FF2B5EF4-FFF2-40B4-BE49-F238E27FC236}">
                <a16:creationId xmlns:a16="http://schemas.microsoft.com/office/drawing/2014/main" id="{EAD28A49-EAB3-7451-6190-FC9C34E144BC}"/>
              </a:ext>
            </a:extLst>
          </p:cNvPr>
          <p:cNvSpPr/>
          <p:nvPr/>
        </p:nvSpPr>
        <p:spPr>
          <a:xfrm rot="5400000">
            <a:off x="1372874" y="4688877"/>
            <a:ext cx="1121262" cy="2240153"/>
          </a:xfrm>
          <a:prstGeom prst="leftUpArrow">
            <a:avLst>
              <a:gd name="adj1" fmla="val 0"/>
              <a:gd name="adj2" fmla="val 2891"/>
              <a:gd name="adj3" fmla="val 5618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Left-Up Arrow 21">
            <a:extLst>
              <a:ext uri="{FF2B5EF4-FFF2-40B4-BE49-F238E27FC236}">
                <a16:creationId xmlns:a16="http://schemas.microsoft.com/office/drawing/2014/main" id="{4092ABD4-6524-534E-CC17-4F4EB80173D5}"/>
              </a:ext>
            </a:extLst>
          </p:cNvPr>
          <p:cNvSpPr/>
          <p:nvPr/>
        </p:nvSpPr>
        <p:spPr>
          <a:xfrm rot="5400000">
            <a:off x="1372873" y="5890176"/>
            <a:ext cx="1121262" cy="2240153"/>
          </a:xfrm>
          <a:prstGeom prst="leftUpArrow">
            <a:avLst>
              <a:gd name="adj1" fmla="val 0"/>
              <a:gd name="adj2" fmla="val 2891"/>
              <a:gd name="adj3" fmla="val 5618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Left-Up Arrow 22">
            <a:extLst>
              <a:ext uri="{FF2B5EF4-FFF2-40B4-BE49-F238E27FC236}">
                <a16:creationId xmlns:a16="http://schemas.microsoft.com/office/drawing/2014/main" id="{25920DBD-A163-D839-6BE2-81CFB0DAE615}"/>
              </a:ext>
            </a:extLst>
          </p:cNvPr>
          <p:cNvSpPr/>
          <p:nvPr/>
        </p:nvSpPr>
        <p:spPr>
          <a:xfrm rot="5400000">
            <a:off x="1372872" y="7089822"/>
            <a:ext cx="1121262" cy="2240153"/>
          </a:xfrm>
          <a:prstGeom prst="leftUpArrow">
            <a:avLst>
              <a:gd name="adj1" fmla="val 0"/>
              <a:gd name="adj2" fmla="val 2891"/>
              <a:gd name="adj3" fmla="val 5618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32B6C5D-BE2C-32F9-478D-529BB209D803}"/>
              </a:ext>
            </a:extLst>
          </p:cNvPr>
          <p:cNvSpPr txBox="1"/>
          <p:nvPr/>
        </p:nvSpPr>
        <p:spPr>
          <a:xfrm>
            <a:off x="862428" y="6303786"/>
            <a:ext cx="79220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/>
              <a:t>CD1d tetramer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E2F4435-EBCF-6D2A-1820-FBE4C4E2ACF5}"/>
              </a:ext>
            </a:extLst>
          </p:cNvPr>
          <p:cNvSpPr txBox="1"/>
          <p:nvPr/>
        </p:nvSpPr>
        <p:spPr>
          <a:xfrm>
            <a:off x="843601" y="7521621"/>
            <a:ext cx="3529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D4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6EE24B4-1545-7244-2F7F-1DF08021894C}"/>
              </a:ext>
            </a:extLst>
          </p:cNvPr>
          <p:cNvSpPr txBox="1"/>
          <p:nvPr/>
        </p:nvSpPr>
        <p:spPr>
          <a:xfrm>
            <a:off x="826864" y="8741191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XCR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BCE43FD-F816-7691-8741-0208AA1CC859}"/>
              </a:ext>
            </a:extLst>
          </p:cNvPr>
          <p:cNvSpPr txBox="1"/>
          <p:nvPr/>
        </p:nvSpPr>
        <p:spPr>
          <a:xfrm rot="16200000">
            <a:off x="553369" y="6060526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CR</a:t>
            </a:r>
            <a:r>
              <a:rPr lang="en-US" sz="800" b="1" dirty="0">
                <a:latin typeface="Symbol" pitchFamily="2" charset="2"/>
              </a:rPr>
              <a:t>b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03F26CD-5165-A033-E1DB-60668B295706}"/>
              </a:ext>
            </a:extLst>
          </p:cNvPr>
          <p:cNvSpPr txBox="1"/>
          <p:nvPr/>
        </p:nvSpPr>
        <p:spPr>
          <a:xfrm rot="16200000">
            <a:off x="567803" y="7255513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CR</a:t>
            </a:r>
            <a:r>
              <a:rPr lang="en-US" sz="800" b="1" dirty="0">
                <a:latin typeface="Symbol" pitchFamily="2" charset="2"/>
              </a:rPr>
              <a:t>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93C8E3F-3F25-FF49-448A-E2EE43CBF6EF}"/>
              </a:ext>
            </a:extLst>
          </p:cNvPr>
          <p:cNvSpPr txBox="1"/>
          <p:nvPr/>
        </p:nvSpPr>
        <p:spPr>
          <a:xfrm rot="16200000">
            <a:off x="575818" y="847948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PD-1</a:t>
            </a:r>
            <a:endParaRPr lang="en-US" sz="800" b="1" dirty="0">
              <a:latin typeface="Symbol" pitchFamily="2" charset="2"/>
            </a:endParaRP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A2C77BC9-223B-8802-8728-F614E563DE8C}"/>
              </a:ext>
            </a:extLst>
          </p:cNvPr>
          <p:cNvCxnSpPr/>
          <p:nvPr/>
        </p:nvCxnSpPr>
        <p:spPr>
          <a:xfrm>
            <a:off x="1621478" y="5966911"/>
            <a:ext cx="0" cy="5523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C8B1BBDE-D5C9-B5F7-1DCD-CA244BA6D771}"/>
              </a:ext>
            </a:extLst>
          </p:cNvPr>
          <p:cNvCxnSpPr/>
          <p:nvPr/>
        </p:nvCxnSpPr>
        <p:spPr>
          <a:xfrm>
            <a:off x="2635269" y="5966911"/>
            <a:ext cx="0" cy="55231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1E5961F0-BEAD-2AA6-1062-8143CA5AC524}"/>
              </a:ext>
            </a:extLst>
          </p:cNvPr>
          <p:cNvCxnSpPr/>
          <p:nvPr/>
        </p:nvCxnSpPr>
        <p:spPr>
          <a:xfrm>
            <a:off x="1621478" y="7196736"/>
            <a:ext cx="0" cy="5523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A8089920-EB1F-70AA-D088-8F0FA191FA09}"/>
              </a:ext>
            </a:extLst>
          </p:cNvPr>
          <p:cNvCxnSpPr/>
          <p:nvPr/>
        </p:nvCxnSpPr>
        <p:spPr>
          <a:xfrm>
            <a:off x="2635269" y="7196736"/>
            <a:ext cx="0" cy="55231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Left-Up Arrow 60">
            <a:extLst>
              <a:ext uri="{FF2B5EF4-FFF2-40B4-BE49-F238E27FC236}">
                <a16:creationId xmlns:a16="http://schemas.microsoft.com/office/drawing/2014/main" id="{EAD3568D-A76B-7741-8496-1B75A99B37DF}"/>
              </a:ext>
            </a:extLst>
          </p:cNvPr>
          <p:cNvSpPr/>
          <p:nvPr/>
        </p:nvSpPr>
        <p:spPr>
          <a:xfrm rot="5400000">
            <a:off x="1369314" y="366182"/>
            <a:ext cx="1121262" cy="2240153"/>
          </a:xfrm>
          <a:prstGeom prst="leftUpArrow">
            <a:avLst>
              <a:gd name="adj1" fmla="val 0"/>
              <a:gd name="adj2" fmla="val 2891"/>
              <a:gd name="adj3" fmla="val 5618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2" name="Left-Up Arrow 61">
            <a:extLst>
              <a:ext uri="{FF2B5EF4-FFF2-40B4-BE49-F238E27FC236}">
                <a16:creationId xmlns:a16="http://schemas.microsoft.com/office/drawing/2014/main" id="{0616ED7F-9E1D-0AC7-BAF7-780BD7841891}"/>
              </a:ext>
            </a:extLst>
          </p:cNvPr>
          <p:cNvSpPr/>
          <p:nvPr/>
        </p:nvSpPr>
        <p:spPr>
          <a:xfrm rot="5400000">
            <a:off x="1369313" y="1567481"/>
            <a:ext cx="1121262" cy="2240153"/>
          </a:xfrm>
          <a:prstGeom prst="leftUpArrow">
            <a:avLst>
              <a:gd name="adj1" fmla="val 0"/>
              <a:gd name="adj2" fmla="val 2891"/>
              <a:gd name="adj3" fmla="val 5618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Left-Up Arrow 62">
            <a:extLst>
              <a:ext uri="{FF2B5EF4-FFF2-40B4-BE49-F238E27FC236}">
                <a16:creationId xmlns:a16="http://schemas.microsoft.com/office/drawing/2014/main" id="{98512038-593D-AF91-6CBB-CE2B71C86DCE}"/>
              </a:ext>
            </a:extLst>
          </p:cNvPr>
          <p:cNvSpPr/>
          <p:nvPr/>
        </p:nvSpPr>
        <p:spPr>
          <a:xfrm rot="5400000">
            <a:off x="1369312" y="2767127"/>
            <a:ext cx="1121262" cy="2240153"/>
          </a:xfrm>
          <a:prstGeom prst="leftUpArrow">
            <a:avLst>
              <a:gd name="adj1" fmla="val 0"/>
              <a:gd name="adj2" fmla="val 2891"/>
              <a:gd name="adj3" fmla="val 5618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B4A7B35-66A2-A7D8-6774-7B3EF8FB1189}"/>
              </a:ext>
            </a:extLst>
          </p:cNvPr>
          <p:cNvSpPr txBox="1"/>
          <p:nvPr/>
        </p:nvSpPr>
        <p:spPr>
          <a:xfrm>
            <a:off x="858868" y="1981091"/>
            <a:ext cx="79220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/>
              <a:t>CD1d tetramer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41B7DD2-C733-6E45-9437-4B1E84F40007}"/>
              </a:ext>
            </a:extLst>
          </p:cNvPr>
          <p:cNvSpPr txBox="1"/>
          <p:nvPr/>
        </p:nvSpPr>
        <p:spPr>
          <a:xfrm>
            <a:off x="840041" y="3198926"/>
            <a:ext cx="3529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D4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14855714-4B00-62D0-4619-36662784949B}"/>
              </a:ext>
            </a:extLst>
          </p:cNvPr>
          <p:cNvSpPr txBox="1"/>
          <p:nvPr/>
        </p:nvSpPr>
        <p:spPr>
          <a:xfrm>
            <a:off x="823304" y="4418496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XCR5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E7433094-6E0A-A8F7-C5E5-CA7CC5DBC3BB}"/>
              </a:ext>
            </a:extLst>
          </p:cNvPr>
          <p:cNvSpPr txBox="1"/>
          <p:nvPr/>
        </p:nvSpPr>
        <p:spPr>
          <a:xfrm rot="16200000">
            <a:off x="549809" y="1737831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CR</a:t>
            </a:r>
            <a:r>
              <a:rPr lang="en-US" sz="800" b="1" dirty="0">
                <a:latin typeface="Symbol" pitchFamily="2" charset="2"/>
              </a:rPr>
              <a:t>b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1B0A82E6-EB41-03D5-A61B-874265C642AC}"/>
              </a:ext>
            </a:extLst>
          </p:cNvPr>
          <p:cNvSpPr txBox="1"/>
          <p:nvPr/>
        </p:nvSpPr>
        <p:spPr>
          <a:xfrm rot="16200000">
            <a:off x="564243" y="2932818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CR</a:t>
            </a:r>
            <a:r>
              <a:rPr lang="en-US" sz="800" b="1" dirty="0">
                <a:latin typeface="Symbol" pitchFamily="2" charset="2"/>
              </a:rPr>
              <a:t>b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81A23D0-7449-8C4F-D50C-68F59A965F79}"/>
              </a:ext>
            </a:extLst>
          </p:cNvPr>
          <p:cNvSpPr txBox="1"/>
          <p:nvPr/>
        </p:nvSpPr>
        <p:spPr>
          <a:xfrm rot="16200000">
            <a:off x="572258" y="415679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PD-1</a:t>
            </a:r>
            <a:endParaRPr lang="en-US" sz="800" b="1" dirty="0">
              <a:latin typeface="Symbol" pitchFamily="2" charset="2"/>
            </a:endParaRPr>
          </a:p>
        </p:txBody>
      </p: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8A1DFB15-36AC-AD3D-F8F7-3934AE9890DA}"/>
              </a:ext>
            </a:extLst>
          </p:cNvPr>
          <p:cNvCxnSpPr/>
          <p:nvPr/>
        </p:nvCxnSpPr>
        <p:spPr>
          <a:xfrm>
            <a:off x="1617918" y="1644216"/>
            <a:ext cx="0" cy="5523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4506530A-6897-E639-213E-6472DDD308D2}"/>
              </a:ext>
            </a:extLst>
          </p:cNvPr>
          <p:cNvCxnSpPr/>
          <p:nvPr/>
        </p:nvCxnSpPr>
        <p:spPr>
          <a:xfrm>
            <a:off x="2631709" y="1644216"/>
            <a:ext cx="0" cy="55231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21EC192E-0E7C-BEC2-581C-421D96E61F46}"/>
              </a:ext>
            </a:extLst>
          </p:cNvPr>
          <p:cNvCxnSpPr>
            <a:cxnSpLocks/>
          </p:cNvCxnSpPr>
          <p:nvPr/>
        </p:nvCxnSpPr>
        <p:spPr>
          <a:xfrm>
            <a:off x="1617918" y="2874041"/>
            <a:ext cx="0" cy="51721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E8069906-09BB-6058-103E-D6B2224C1689}"/>
              </a:ext>
            </a:extLst>
          </p:cNvPr>
          <p:cNvCxnSpPr>
            <a:cxnSpLocks/>
          </p:cNvCxnSpPr>
          <p:nvPr/>
        </p:nvCxnSpPr>
        <p:spPr>
          <a:xfrm>
            <a:off x="2631709" y="2874041"/>
            <a:ext cx="0" cy="49963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4D227869-63B9-AB79-6FFF-1E6EC1D182EC}"/>
              </a:ext>
            </a:extLst>
          </p:cNvPr>
          <p:cNvSpPr txBox="1"/>
          <p:nvPr/>
        </p:nvSpPr>
        <p:spPr>
          <a:xfrm>
            <a:off x="428391" y="67029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83E42F3-EE6C-80CC-CB76-7A38688A4329}"/>
              </a:ext>
            </a:extLst>
          </p:cNvPr>
          <p:cNvSpPr txBox="1"/>
          <p:nvPr/>
        </p:nvSpPr>
        <p:spPr>
          <a:xfrm>
            <a:off x="434137" y="214146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9ED1254-B0BC-A5FA-8E74-E6488CD702AE}"/>
              </a:ext>
            </a:extLst>
          </p:cNvPr>
          <p:cNvSpPr txBox="1"/>
          <p:nvPr/>
        </p:nvSpPr>
        <p:spPr>
          <a:xfrm>
            <a:off x="457691" y="339234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A8EBEBC-D2CE-4A24-896F-8C2ABF19499C}"/>
              </a:ext>
            </a:extLst>
          </p:cNvPr>
          <p:cNvSpPr txBox="1"/>
          <p:nvPr/>
        </p:nvSpPr>
        <p:spPr>
          <a:xfrm>
            <a:off x="484639" y="5201423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895B7B4-1476-9269-6770-D5E6C3DAE365}"/>
              </a:ext>
            </a:extLst>
          </p:cNvPr>
          <p:cNvSpPr txBox="1"/>
          <p:nvPr/>
        </p:nvSpPr>
        <p:spPr>
          <a:xfrm>
            <a:off x="453497" y="6408209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34B6F28-E525-14F9-2E42-C04B6634E777}"/>
              </a:ext>
            </a:extLst>
          </p:cNvPr>
          <p:cNvSpPr txBox="1"/>
          <p:nvPr/>
        </p:nvSpPr>
        <p:spPr>
          <a:xfrm>
            <a:off x="446968" y="765224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CED955C-E98B-8A47-C461-5B7EE0A75373}"/>
              </a:ext>
            </a:extLst>
          </p:cNvPr>
          <p:cNvSpPr txBox="1"/>
          <p:nvPr/>
        </p:nvSpPr>
        <p:spPr>
          <a:xfrm>
            <a:off x="465761" y="451235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leen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A84DD0C-16FB-CC1D-F59D-177C5DE2FD68}"/>
              </a:ext>
            </a:extLst>
          </p:cNvPr>
          <p:cNvSpPr txBox="1"/>
          <p:nvPr/>
        </p:nvSpPr>
        <p:spPr>
          <a:xfrm>
            <a:off x="1124588" y="761423"/>
            <a:ext cx="599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D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8FA683E-E628-0999-FC3D-4A90BD9B1DF8}"/>
              </a:ext>
            </a:extLst>
          </p:cNvPr>
          <p:cNvSpPr txBox="1"/>
          <p:nvPr/>
        </p:nvSpPr>
        <p:spPr>
          <a:xfrm>
            <a:off x="2187893" y="770923"/>
            <a:ext cx="577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FD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95D45412-7E89-814E-21A7-658A96B5E507}"/>
              </a:ext>
            </a:extLst>
          </p:cNvPr>
          <p:cNvSpPr txBox="1"/>
          <p:nvPr/>
        </p:nvSpPr>
        <p:spPr>
          <a:xfrm>
            <a:off x="1163254" y="5054780"/>
            <a:ext cx="599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D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0874650-EB1D-620A-BA28-26E532DC5B59}"/>
              </a:ext>
            </a:extLst>
          </p:cNvPr>
          <p:cNvSpPr txBox="1"/>
          <p:nvPr/>
        </p:nvSpPr>
        <p:spPr>
          <a:xfrm>
            <a:off x="2226559" y="5064280"/>
            <a:ext cx="577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FD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CF20034D-5754-870D-D1FC-328842D27350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187667" y="1027167"/>
            <a:ext cx="1054439" cy="998352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D361AE0D-645B-80DC-5591-B72813868ABC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242542" y="1012632"/>
            <a:ext cx="1108696" cy="998352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8B6BB881-ED69-3968-CA1F-9C2D011A7CFA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253669" y="2164064"/>
            <a:ext cx="1149620" cy="1008041"/>
          </a:xfrm>
          <a:prstGeom prst="rect">
            <a:avLst/>
          </a:prstGeom>
        </p:spPr>
      </p:pic>
      <p:pic>
        <p:nvPicPr>
          <p:cNvPr id="70" name="Picture 69">
            <a:extLst>
              <a:ext uri="{FF2B5EF4-FFF2-40B4-BE49-F238E27FC236}">
                <a16:creationId xmlns:a16="http://schemas.microsoft.com/office/drawing/2014/main" id="{C274F9D5-6EFD-7B9D-C3A1-234ED1A7887E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174606" y="3226062"/>
            <a:ext cx="2240153" cy="1610488"/>
          </a:xfrm>
          <a:prstGeom prst="rect">
            <a:avLst/>
          </a:prstGeom>
        </p:spPr>
      </p:pic>
      <p:sp>
        <p:nvSpPr>
          <p:cNvPr id="92" name="TextBox 91">
            <a:extLst>
              <a:ext uri="{FF2B5EF4-FFF2-40B4-BE49-F238E27FC236}">
                <a16:creationId xmlns:a16="http://schemas.microsoft.com/office/drawing/2014/main" id="{DE9EED3E-DAEF-87B1-CBEF-B912B5997F0D}"/>
              </a:ext>
            </a:extLst>
          </p:cNvPr>
          <p:cNvSpPr txBox="1"/>
          <p:nvPr/>
        </p:nvSpPr>
        <p:spPr>
          <a:xfrm>
            <a:off x="2949370" y="67029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DD0470FB-FA3C-3BD8-8BA0-D77790C047DD}"/>
              </a:ext>
            </a:extLst>
          </p:cNvPr>
          <p:cNvSpPr txBox="1"/>
          <p:nvPr/>
        </p:nvSpPr>
        <p:spPr>
          <a:xfrm>
            <a:off x="2912702" y="213158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E2B0C040-0F81-720D-52F1-AAEF3A0CABC3}"/>
              </a:ext>
            </a:extLst>
          </p:cNvPr>
          <p:cNvSpPr txBox="1"/>
          <p:nvPr/>
        </p:nvSpPr>
        <p:spPr>
          <a:xfrm>
            <a:off x="2973753" y="338489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pic>
        <p:nvPicPr>
          <p:cNvPr id="123" name="Picture 122">
            <a:extLst>
              <a:ext uri="{FF2B5EF4-FFF2-40B4-BE49-F238E27FC236}">
                <a16:creationId xmlns:a16="http://schemas.microsoft.com/office/drawing/2014/main" id="{C02E60BE-D8A4-5C4D-D758-A4C8964CFDD1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240036" y="5293488"/>
            <a:ext cx="1047113" cy="1007916"/>
          </a:xfrm>
          <a:prstGeom prst="rect">
            <a:avLst/>
          </a:prstGeom>
        </p:spPr>
      </p:pic>
      <p:pic>
        <p:nvPicPr>
          <p:cNvPr id="124" name="Picture 123">
            <a:extLst>
              <a:ext uri="{FF2B5EF4-FFF2-40B4-BE49-F238E27FC236}">
                <a16:creationId xmlns:a16="http://schemas.microsoft.com/office/drawing/2014/main" id="{18CEF118-184A-5253-B2EF-16065F9F29EB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337475" y="5264979"/>
            <a:ext cx="1213934" cy="1036425"/>
          </a:xfrm>
          <a:prstGeom prst="rect">
            <a:avLst/>
          </a:prstGeom>
        </p:spPr>
      </p:pic>
      <p:pic>
        <p:nvPicPr>
          <p:cNvPr id="125" name="Picture 124">
            <a:extLst>
              <a:ext uri="{FF2B5EF4-FFF2-40B4-BE49-F238E27FC236}">
                <a16:creationId xmlns:a16="http://schemas.microsoft.com/office/drawing/2014/main" id="{FFAA472D-3BB2-27C5-AC5D-5F4F0CF6D954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177432" y="2130874"/>
            <a:ext cx="1088125" cy="1041324"/>
          </a:xfrm>
          <a:prstGeom prst="rect">
            <a:avLst/>
          </a:prstGeom>
        </p:spPr>
      </p:pic>
      <p:pic>
        <p:nvPicPr>
          <p:cNvPr id="126" name="Picture 125">
            <a:extLst>
              <a:ext uri="{FF2B5EF4-FFF2-40B4-BE49-F238E27FC236}">
                <a16:creationId xmlns:a16="http://schemas.microsoft.com/office/drawing/2014/main" id="{8D7F3E9A-7C70-B561-C16D-00BF11563010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3269024" y="6501733"/>
            <a:ext cx="1048419" cy="1087876"/>
          </a:xfrm>
          <a:prstGeom prst="rect">
            <a:avLst/>
          </a:prstGeom>
        </p:spPr>
      </p:pic>
      <p:pic>
        <p:nvPicPr>
          <p:cNvPr id="127" name="Picture 126">
            <a:extLst>
              <a:ext uri="{FF2B5EF4-FFF2-40B4-BE49-F238E27FC236}">
                <a16:creationId xmlns:a16="http://schemas.microsoft.com/office/drawing/2014/main" id="{43143998-D38A-262D-F572-BCCD5782643D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314024" y="6525013"/>
            <a:ext cx="1237385" cy="1043861"/>
          </a:xfrm>
          <a:prstGeom prst="rect">
            <a:avLst/>
          </a:prstGeom>
        </p:spPr>
      </p:pic>
      <p:pic>
        <p:nvPicPr>
          <p:cNvPr id="128" name="Picture 127">
            <a:extLst>
              <a:ext uri="{FF2B5EF4-FFF2-40B4-BE49-F238E27FC236}">
                <a16:creationId xmlns:a16="http://schemas.microsoft.com/office/drawing/2014/main" id="{21F634F5-AB32-5BB8-1DD9-F0A6220AE2AA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237542" y="7674231"/>
            <a:ext cx="2313867" cy="1444603"/>
          </a:xfrm>
          <a:prstGeom prst="rect">
            <a:avLst/>
          </a:prstGeom>
        </p:spPr>
      </p:pic>
      <p:sp>
        <p:nvSpPr>
          <p:cNvPr id="132" name="TextBox 131">
            <a:extLst>
              <a:ext uri="{FF2B5EF4-FFF2-40B4-BE49-F238E27FC236}">
                <a16:creationId xmlns:a16="http://schemas.microsoft.com/office/drawing/2014/main" id="{5FD439E0-8F26-05B2-4CCA-DFD614AEB2CD}"/>
              </a:ext>
            </a:extLst>
          </p:cNvPr>
          <p:cNvSpPr txBox="1"/>
          <p:nvPr/>
        </p:nvSpPr>
        <p:spPr>
          <a:xfrm>
            <a:off x="2990169" y="520484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E994DA9B-7CD2-1B4C-AD80-B7ABCC29F44D}"/>
              </a:ext>
            </a:extLst>
          </p:cNvPr>
          <p:cNvSpPr txBox="1"/>
          <p:nvPr/>
        </p:nvSpPr>
        <p:spPr>
          <a:xfrm>
            <a:off x="2990169" y="6484512"/>
            <a:ext cx="344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E13A2B22-4063-C674-B92F-E02888CE7E0B}"/>
              </a:ext>
            </a:extLst>
          </p:cNvPr>
          <p:cNvSpPr txBox="1"/>
          <p:nvPr/>
        </p:nvSpPr>
        <p:spPr>
          <a:xfrm>
            <a:off x="3032695" y="762279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A3101B68-25BF-A91E-FB9B-3110DBFECC71}"/>
              </a:ext>
            </a:extLst>
          </p:cNvPr>
          <p:cNvSpPr txBox="1"/>
          <p:nvPr/>
        </p:nvSpPr>
        <p:spPr>
          <a:xfrm>
            <a:off x="5631717" y="515845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0D15DAD3-6830-839E-7205-D94D4586428D}"/>
              </a:ext>
            </a:extLst>
          </p:cNvPr>
          <p:cNvSpPr txBox="1"/>
          <p:nvPr/>
        </p:nvSpPr>
        <p:spPr>
          <a:xfrm>
            <a:off x="5461638" y="635776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D83C0407-6E1E-9F69-76E9-171941169484}"/>
              </a:ext>
            </a:extLst>
          </p:cNvPr>
          <p:cNvSpPr txBox="1"/>
          <p:nvPr/>
        </p:nvSpPr>
        <p:spPr>
          <a:xfrm>
            <a:off x="5511707" y="768995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</a:p>
        </p:txBody>
      </p:sp>
      <p:grpSp>
        <p:nvGrpSpPr>
          <p:cNvPr id="43" name="Group 42">
            <a:extLst>
              <a:ext uri="{FF2B5EF4-FFF2-40B4-BE49-F238E27FC236}">
                <a16:creationId xmlns:a16="http://schemas.microsoft.com/office/drawing/2014/main" id="{69CF1C2A-3F7B-3DAC-055B-DF15006CF718}"/>
              </a:ext>
            </a:extLst>
          </p:cNvPr>
          <p:cNvGrpSpPr/>
          <p:nvPr/>
        </p:nvGrpSpPr>
        <p:grpSpPr>
          <a:xfrm>
            <a:off x="5194136" y="789023"/>
            <a:ext cx="458274" cy="338554"/>
            <a:chOff x="4865613" y="668021"/>
            <a:chExt cx="458274" cy="338554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81EEE62-FD06-BF9D-0CCA-EB38025E8416}"/>
                </a:ext>
              </a:extLst>
            </p:cNvPr>
            <p:cNvSpPr txBox="1"/>
            <p:nvPr/>
          </p:nvSpPr>
          <p:spPr>
            <a:xfrm>
              <a:off x="4926021" y="668021"/>
              <a:ext cx="3978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/>
                <a:t>NCD</a:t>
              </a:r>
            </a:p>
            <a:p>
              <a:pPr algn="ctr"/>
              <a:r>
                <a:rPr lang="en-US" sz="800" dirty="0"/>
                <a:t>HFD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3B8F137E-29D4-DBCC-3D6C-965DF22B38A3}"/>
                </a:ext>
              </a:extLst>
            </p:cNvPr>
            <p:cNvSpPr/>
            <p:nvPr/>
          </p:nvSpPr>
          <p:spPr>
            <a:xfrm>
              <a:off x="4865613" y="741629"/>
              <a:ext cx="133350" cy="65818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4C353B87-C994-7B39-1E1A-24FC8CFA7011}"/>
                </a:ext>
              </a:extLst>
            </p:cNvPr>
            <p:cNvSpPr/>
            <p:nvPr/>
          </p:nvSpPr>
          <p:spPr>
            <a:xfrm>
              <a:off x="4865613" y="853433"/>
              <a:ext cx="133350" cy="65818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0D355274-88A4-7927-5578-B1BECC072B10}"/>
              </a:ext>
            </a:extLst>
          </p:cNvPr>
          <p:cNvSpPr txBox="1"/>
          <p:nvPr/>
        </p:nvSpPr>
        <p:spPr>
          <a:xfrm>
            <a:off x="453559" y="4805266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2EB2261B-6413-02C4-E84D-699D755400EA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5934221" y="974796"/>
            <a:ext cx="996302" cy="1223005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3FB091A0-098F-4F2D-C4DD-973B695A55FD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5877806" y="2278826"/>
            <a:ext cx="1109132" cy="1190429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AF93EC74-2998-E351-E143-CB8DA5FA0826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5880961" y="3550280"/>
            <a:ext cx="1102822" cy="1186793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295B8443-7249-7567-0A5C-C301F74B1450}"/>
              </a:ext>
            </a:extLst>
          </p:cNvPr>
          <p:cNvSpPr txBox="1"/>
          <p:nvPr/>
        </p:nvSpPr>
        <p:spPr>
          <a:xfrm>
            <a:off x="5738995" y="708998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C6153DB-2EBD-5EFA-76FE-ECEC267D2FF3}"/>
              </a:ext>
            </a:extLst>
          </p:cNvPr>
          <p:cNvSpPr txBox="1"/>
          <p:nvPr/>
        </p:nvSpPr>
        <p:spPr>
          <a:xfrm>
            <a:off x="5736787" y="208111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9DD49D4-767A-1C61-B336-F59EA6B5B683}"/>
              </a:ext>
            </a:extLst>
          </p:cNvPr>
          <p:cNvSpPr txBox="1"/>
          <p:nvPr/>
        </p:nvSpPr>
        <p:spPr>
          <a:xfrm>
            <a:off x="5740967" y="3331300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BC561806-A43C-496D-6305-47A5909EDBA0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825405" y="5201423"/>
            <a:ext cx="1213934" cy="1315625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EB15AB15-3351-D8D2-547F-93FD65E3D8A3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5875181" y="6528858"/>
            <a:ext cx="1114383" cy="1266079"/>
          </a:xfrm>
          <a:prstGeom prst="rect">
            <a:avLst/>
          </a:prstGeom>
        </p:spPr>
      </p:pic>
      <p:pic>
        <p:nvPicPr>
          <p:cNvPr id="84" name="Picture 83">
            <a:extLst>
              <a:ext uri="{FF2B5EF4-FFF2-40B4-BE49-F238E27FC236}">
                <a16:creationId xmlns:a16="http://schemas.microsoft.com/office/drawing/2014/main" id="{B81C441C-8F46-4B95-F4B9-6B446090FC4D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5842607" y="7936502"/>
            <a:ext cx="1179530" cy="12932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52480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2183D9B-92B9-6BD3-B26D-8FB701BC264C}"/>
              </a:ext>
            </a:extLst>
          </p:cNvPr>
          <p:cNvSpPr txBox="1"/>
          <p:nvPr/>
        </p:nvSpPr>
        <p:spPr>
          <a:xfrm>
            <a:off x="228600" y="648623"/>
            <a:ext cx="7315200" cy="3600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HFD does not promote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20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H</a:t>
            </a:r>
            <a:r>
              <a:rPr lang="en-US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PH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fferentiation in the liver or spleen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flow cytometry plots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staining in NCD or HFD mice spleens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ummary of quantified splenic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cR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CD1d tetramer+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frequency or number in NCD or HFD mice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presentative flow cytometry plots of CD4+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lus quantification of frequency and number of splenic CD4+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in NCD or HFD spleen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presentative flow cytometry plots of PD-1 and CXCR5 expression by splenic CD4+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in NCD or HFD spleen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Summary of flow cytometry determined PD-1 and CXCR5 +/- cell subsets as a percentage of splenic CD4+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in NCD (black bars) or HFD (red bars) -fed mice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Expression of Bcl-6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ICO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T-bet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b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(purple) compared to PD-1- CD4+ T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(white), data pooled from NCD and HFD spleens. Representative flow cytometry plots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staining in NCD or HFD mice liver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Summary of quantified hepatic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cR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CD1d tetramer+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frequency or number in NCD or HFD mice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presentative flow cytometry plots of CD4+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lus quantification of frequency and number of hepatic CD4+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in NCD or HFD liver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Representative flow cytometry plots of PD-1 and CXCR5 expression by hepatic CD4+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in NCD or HFD liver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Summary of flow cytometry determined PD-1 and CXCR5 +/- cell subsets as a percentage of hepatic CD4+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in NCD (black bars) or HFD (red bars) -fed mice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Expression of Bcl-6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ICO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T-bet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b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(purple) compared to PD-1- CD4+ T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(white), data pooled from NCD and HFD livers. Pool of 2 independent experiments. 4 mice/grp. Bars indicate mean ± SEM; [Student’s t-test (two-tailed)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-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 one-way ANOVA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,D,F,K,M,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]; *p &lt; 0.05, **p &lt; 0.01, ***p &lt; 0.001, ****p &lt; 0.0001.</a:t>
            </a:r>
          </a:p>
        </p:txBody>
      </p:sp>
    </p:spTree>
    <p:extLst>
      <p:ext uri="{BB962C8B-B14F-4D97-AF65-F5344CB8AC3E}">
        <p14:creationId xmlns:p14="http://schemas.microsoft.com/office/powerpoint/2010/main" val="387053101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DFC6FD59-F367-5207-DE1D-6929AE46DC73}"/>
              </a:ext>
            </a:extLst>
          </p:cNvPr>
          <p:cNvGrpSpPr/>
          <p:nvPr/>
        </p:nvGrpSpPr>
        <p:grpSpPr>
          <a:xfrm>
            <a:off x="639879" y="514157"/>
            <a:ext cx="6105050" cy="6860037"/>
            <a:chOff x="639879" y="514157"/>
            <a:chExt cx="6492642" cy="7263160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C0C8BE1D-00F0-1C9E-6B19-B7A8573253E8}"/>
                </a:ext>
              </a:extLst>
            </p:cNvPr>
            <p:cNvSpPr txBox="1"/>
            <p:nvPr/>
          </p:nvSpPr>
          <p:spPr>
            <a:xfrm>
              <a:off x="642526" y="522965"/>
              <a:ext cx="371709" cy="3258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 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7534D29-6FE4-1335-F951-FEA032634500}"/>
                </a:ext>
              </a:extLst>
            </p:cNvPr>
            <p:cNvSpPr txBox="1"/>
            <p:nvPr/>
          </p:nvSpPr>
          <p:spPr>
            <a:xfrm>
              <a:off x="3885177" y="516016"/>
              <a:ext cx="371982" cy="3258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 </a:t>
              </a:r>
            </a:p>
          </p:txBody>
        </p:sp>
        <p:pic>
          <p:nvPicPr>
            <p:cNvPr id="6" name="Picture 5" descr="A picture containing text, font, diagram&#10;&#10;Description automatically generated">
              <a:extLst>
                <a:ext uri="{FF2B5EF4-FFF2-40B4-BE49-F238E27FC236}">
                  <a16:creationId xmlns:a16="http://schemas.microsoft.com/office/drawing/2014/main" id="{DAC9E6FB-2CB9-E915-F551-5195353ACC6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97769" y="618866"/>
              <a:ext cx="2429457" cy="1470858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CB8C9CB7-DC40-2B69-ACAD-22E245ECEAB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55279" y="2538619"/>
              <a:ext cx="1434926" cy="1263301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325BD7F-46D2-F712-62FB-337C1A4438EB}"/>
                </a:ext>
              </a:extLst>
            </p:cNvPr>
            <p:cNvSpPr txBox="1"/>
            <p:nvPr/>
          </p:nvSpPr>
          <p:spPr>
            <a:xfrm>
              <a:off x="4761885" y="1961354"/>
              <a:ext cx="569975" cy="239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Spleen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0D5A34D-8952-C22F-AE8F-FC818FF5E044}"/>
                </a:ext>
              </a:extLst>
            </p:cNvPr>
            <p:cNvSpPr txBox="1"/>
            <p:nvPr/>
          </p:nvSpPr>
          <p:spPr>
            <a:xfrm>
              <a:off x="6267089" y="1961354"/>
              <a:ext cx="449231" cy="239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Liver</a:t>
              </a:r>
            </a:p>
          </p:txBody>
        </p: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5233DC8C-C1B5-7903-9225-1A106ED3ED3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260784" y="2538619"/>
              <a:ext cx="1432053" cy="1321679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A42639FD-792E-7054-913D-58773BD62BE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124097" y="4346740"/>
              <a:ext cx="1334949" cy="1361656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76E212A3-1808-A4B9-F95F-F6A4DDBD45E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55279" y="4344719"/>
              <a:ext cx="1342417" cy="1362661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7ED1E506-5B7C-909B-1BB9-C800F2C09A6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290205" y="4344719"/>
              <a:ext cx="1339731" cy="1373009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553E39D7-FD74-AF96-16CE-39D85DC3632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657774" y="4408114"/>
              <a:ext cx="1288618" cy="1289481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82308657-5DF9-BDCC-D73D-1CF725B2A3C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133331" y="800504"/>
              <a:ext cx="1427655" cy="1180724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4C19DDF6-3612-71D8-D608-CA102A2F960C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598381" y="754420"/>
              <a:ext cx="1412740" cy="1226808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67FBFDE-A150-ADB5-8AEA-1D6CD61C9541}"/>
                </a:ext>
              </a:extLst>
            </p:cNvPr>
            <p:cNvSpPr txBox="1"/>
            <p:nvPr/>
          </p:nvSpPr>
          <p:spPr>
            <a:xfrm>
              <a:off x="5009210" y="514157"/>
              <a:ext cx="10704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+ T Cells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70AE392-96D2-5837-A1D3-B4654EA9B597}"/>
                </a:ext>
              </a:extLst>
            </p:cNvPr>
            <p:cNvSpPr txBox="1"/>
            <p:nvPr/>
          </p:nvSpPr>
          <p:spPr>
            <a:xfrm>
              <a:off x="1783546" y="2182426"/>
              <a:ext cx="7938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sz="12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H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ells</a:t>
              </a:r>
            </a:p>
          </p:txBody>
        </p:sp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FA7C8978-EE2D-9C41-9B42-95666EECCC9C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133331" y="2539649"/>
              <a:ext cx="1494317" cy="1321679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3A3B5983-2822-0F7A-3375-C60B7D4A16F4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5657774" y="2532506"/>
              <a:ext cx="1434926" cy="1324331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D72E9E7D-2075-ED48-38B5-53F8637BBD2B}"/>
                </a:ext>
              </a:extLst>
            </p:cNvPr>
            <p:cNvSpPr txBox="1"/>
            <p:nvPr/>
          </p:nvSpPr>
          <p:spPr>
            <a:xfrm>
              <a:off x="5265136" y="2191102"/>
              <a:ext cx="7938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sz="12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ells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A859F758-09CA-15B1-A424-52685D1381B9}"/>
                </a:ext>
              </a:extLst>
            </p:cNvPr>
            <p:cNvSpPr txBox="1"/>
            <p:nvPr/>
          </p:nvSpPr>
          <p:spPr>
            <a:xfrm>
              <a:off x="648303" y="2151326"/>
              <a:ext cx="363457" cy="3258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sz="1400" dirty="0"/>
                <a:t> 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01B3857-E415-46BF-B2A7-5697583FFBC0}"/>
                </a:ext>
              </a:extLst>
            </p:cNvPr>
            <p:cNvSpPr txBox="1"/>
            <p:nvPr/>
          </p:nvSpPr>
          <p:spPr>
            <a:xfrm>
              <a:off x="3893601" y="2150760"/>
              <a:ext cx="382211" cy="3258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 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6D46DA4-2F55-DEA1-F211-D47E5C192BE3}"/>
                </a:ext>
              </a:extLst>
            </p:cNvPr>
            <p:cNvSpPr txBox="1"/>
            <p:nvPr/>
          </p:nvSpPr>
          <p:spPr>
            <a:xfrm>
              <a:off x="1411231" y="3829783"/>
              <a:ext cx="569975" cy="239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Spleen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CC04B6AD-0BEA-46E4-4229-364BDA15FEA6}"/>
                </a:ext>
              </a:extLst>
            </p:cNvPr>
            <p:cNvSpPr txBox="1"/>
            <p:nvPr/>
          </p:nvSpPr>
          <p:spPr>
            <a:xfrm>
              <a:off x="2846331" y="3829783"/>
              <a:ext cx="449231" cy="239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Liver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1B140B5C-3B0F-CE30-E4E1-F119F629B051}"/>
                </a:ext>
              </a:extLst>
            </p:cNvPr>
            <p:cNvSpPr txBox="1"/>
            <p:nvPr/>
          </p:nvSpPr>
          <p:spPr>
            <a:xfrm>
              <a:off x="4761885" y="3829783"/>
              <a:ext cx="569975" cy="239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Spleen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EDD4DCF-7A02-C2F8-1768-DADFB00D9BF4}"/>
                </a:ext>
              </a:extLst>
            </p:cNvPr>
            <p:cNvSpPr txBox="1"/>
            <p:nvPr/>
          </p:nvSpPr>
          <p:spPr>
            <a:xfrm>
              <a:off x="6267089" y="3829783"/>
              <a:ext cx="449231" cy="239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Liver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A34B359B-F55C-F20D-9C27-C48F57105F21}"/>
                </a:ext>
              </a:extLst>
            </p:cNvPr>
            <p:cNvSpPr txBox="1"/>
            <p:nvPr/>
          </p:nvSpPr>
          <p:spPr>
            <a:xfrm>
              <a:off x="1809466" y="4043166"/>
              <a:ext cx="8451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sz="12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H1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ells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8A7197A-CC57-C8D0-B347-B057F8614FAB}"/>
                </a:ext>
              </a:extLst>
            </p:cNvPr>
            <p:cNvSpPr txBox="1"/>
            <p:nvPr/>
          </p:nvSpPr>
          <p:spPr>
            <a:xfrm>
              <a:off x="5291056" y="4051842"/>
              <a:ext cx="8451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sz="12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1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ells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3D156B88-6022-D9CD-5F42-2DDAF798F475}"/>
                </a:ext>
              </a:extLst>
            </p:cNvPr>
            <p:cNvSpPr txBox="1"/>
            <p:nvPr/>
          </p:nvSpPr>
          <p:spPr>
            <a:xfrm>
              <a:off x="1344506" y="5669334"/>
              <a:ext cx="569975" cy="239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Spleen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A95F1463-CA05-FB81-4B7F-52DBC8D6853F}"/>
                </a:ext>
              </a:extLst>
            </p:cNvPr>
            <p:cNvSpPr txBox="1"/>
            <p:nvPr/>
          </p:nvSpPr>
          <p:spPr>
            <a:xfrm>
              <a:off x="2779606" y="5669334"/>
              <a:ext cx="449231" cy="239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Liver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6F93B058-7039-AC0B-3AE0-F35A46F87CAD}"/>
                </a:ext>
              </a:extLst>
            </p:cNvPr>
            <p:cNvSpPr txBox="1"/>
            <p:nvPr/>
          </p:nvSpPr>
          <p:spPr>
            <a:xfrm>
              <a:off x="4695160" y="5669334"/>
              <a:ext cx="569975" cy="239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Spleen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45FF09A9-64C9-3737-DC23-5E5CAF91F0C0}"/>
                </a:ext>
              </a:extLst>
            </p:cNvPr>
            <p:cNvSpPr txBox="1"/>
            <p:nvPr/>
          </p:nvSpPr>
          <p:spPr>
            <a:xfrm>
              <a:off x="6200365" y="5669334"/>
              <a:ext cx="449231" cy="239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Liver</a:t>
              </a:r>
            </a:p>
          </p:txBody>
        </p:sp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7CCA775A-D96A-0862-FA92-777A7554041D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4097219" y="6389318"/>
              <a:ext cx="1518548" cy="1361656"/>
            </a:xfrm>
            <a:prstGeom prst="rect">
              <a:avLst/>
            </a:prstGeom>
          </p:spPr>
        </p:pic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CE7D40B9-E0D1-8A84-F3A3-B0B57E1D8249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5560985" y="6389317"/>
              <a:ext cx="1571536" cy="1388000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C67D092C-6153-52BE-54F2-B9903841D682}"/>
                </a:ext>
              </a:extLst>
            </p:cNvPr>
            <p:cNvSpPr txBox="1"/>
            <p:nvPr/>
          </p:nvSpPr>
          <p:spPr>
            <a:xfrm>
              <a:off x="4718375" y="6038625"/>
              <a:ext cx="16626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lass-switched B Cells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E6EEE2C6-63CF-C98A-38D5-6A53BA1CC5E4}"/>
                </a:ext>
              </a:extLst>
            </p:cNvPr>
            <p:cNvSpPr txBox="1"/>
            <p:nvPr/>
          </p:nvSpPr>
          <p:spPr>
            <a:xfrm>
              <a:off x="1253321" y="6038625"/>
              <a:ext cx="18137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rminal Center B Cells</a:t>
              </a:r>
            </a:p>
          </p:txBody>
        </p:sp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39AE55C5-C4D4-B8DE-EC63-6078C2C04CD9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855280" y="6337478"/>
              <a:ext cx="1522906" cy="1413497"/>
            </a:xfrm>
            <a:prstGeom prst="rect">
              <a:avLst/>
            </a:prstGeom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BC46DE82-4755-2D8D-EFC2-0451F7A491A5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2309790" y="6389317"/>
              <a:ext cx="1511420" cy="1375329"/>
            </a:xfrm>
            <a:prstGeom prst="rect">
              <a:avLst/>
            </a:prstGeom>
          </p:spPr>
        </p:pic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EDE32D8E-4978-3458-E940-0271522C327A}"/>
                </a:ext>
              </a:extLst>
            </p:cNvPr>
            <p:cNvSpPr txBox="1"/>
            <p:nvPr/>
          </p:nvSpPr>
          <p:spPr>
            <a:xfrm>
              <a:off x="667553" y="4066310"/>
              <a:ext cx="360048" cy="3258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 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B574DE7E-8248-E98B-1D16-A4FB0169DDD6}"/>
                </a:ext>
              </a:extLst>
            </p:cNvPr>
            <p:cNvSpPr txBox="1"/>
            <p:nvPr/>
          </p:nvSpPr>
          <p:spPr>
            <a:xfrm>
              <a:off x="3912851" y="4065744"/>
              <a:ext cx="341296" cy="3258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US" sz="1400" dirty="0"/>
                <a:t> 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A3DF5530-A73B-EA85-E58F-2EAAF36FA495}"/>
                </a:ext>
              </a:extLst>
            </p:cNvPr>
            <p:cNvSpPr txBox="1"/>
            <p:nvPr/>
          </p:nvSpPr>
          <p:spPr>
            <a:xfrm>
              <a:off x="639879" y="6049539"/>
              <a:ext cx="331583" cy="325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r>
                <a:rPr lang="en-US" sz="1400" dirty="0"/>
                <a:t> 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06E29543-8397-B5A1-F753-C0828424FD95}"/>
                </a:ext>
              </a:extLst>
            </p:cNvPr>
            <p:cNvSpPr txBox="1"/>
            <p:nvPr/>
          </p:nvSpPr>
          <p:spPr>
            <a:xfrm>
              <a:off x="3885177" y="6048973"/>
              <a:ext cx="331583" cy="325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sz="1400" dirty="0"/>
                <a:t> </a:t>
              </a:r>
            </a:p>
          </p:txBody>
        </p:sp>
      </p:grpSp>
      <p:sp>
        <p:nvSpPr>
          <p:cNvPr id="63" name="TextBox 62">
            <a:extLst>
              <a:ext uri="{FF2B5EF4-FFF2-40B4-BE49-F238E27FC236}">
                <a16:creationId xmlns:a16="http://schemas.microsoft.com/office/drawing/2014/main" id="{785982B1-1F86-DC33-C8CA-AB06FD00971E}"/>
              </a:ext>
            </a:extLst>
          </p:cNvPr>
          <p:cNvSpPr txBox="1"/>
          <p:nvPr/>
        </p:nvSpPr>
        <p:spPr>
          <a:xfrm>
            <a:off x="258499" y="7506354"/>
            <a:ext cx="73152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CXCR3-blockade results in expanded T</a:t>
            </a:r>
            <a:r>
              <a:rPr lang="en-US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H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</a:t>
            </a:r>
            <a:r>
              <a:rPr lang="en-US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s in HFD spleen and increased GC activity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FD-fed WT mice were injected IP with anti-mouse CXCR3 and CXCL9 blocking antibodies (red) or hamster IgG control (black) every other day for 14 day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Flow cytometry analysis of spleen and liver at day 14 reveals numbers of CD4+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cR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T cells after treatment as outlined in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Cell numbers of PD-1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XCR5+ T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PD-1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XCR5- T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ithin HFD spleen (left) and liver (right). T-bet+ PD-1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XCR5+ T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T-bet+ PD-1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XCR5- T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ell numbers in HFD spleen and liver. Numbers of total germinal center (GL7+ CD95+) B cells (left), and T-bet+ CD11c+ B cells expressing GC markers (right) in HFD spleen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Numbers of total class-switched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g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IgM-) B cells (left) and class-switched T-bet+ CD11c+ B cells (right) in HFD spleen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Symbols represent individual mice. One independent experiment. N=5 mice/grp. Bars indicate mean ± SEM; [Mann-Whitney test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]; *p &lt; 0.05, **p &lt; 0.01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11991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8305EEA-D88D-2FED-31F1-9D5736D1ED09}"/>
              </a:ext>
            </a:extLst>
          </p:cNvPr>
          <p:cNvSpPr txBox="1"/>
          <p:nvPr/>
        </p:nvSpPr>
        <p:spPr>
          <a:xfrm>
            <a:off x="228600" y="4113162"/>
            <a:ext cx="73152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 Mice deficient in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bet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B cells have reduced IgG2c but compensate with increases in other isotypes, regardless of diet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um from female mice fed a NCD or HFD for 12 weeks was tested by ELISA for total IgG1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IgG2b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IgG2c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IgG3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tibody concentrations. Sera from the same mice was also tested by ELISA for total IgG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s well as subclasses IgG2b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IgG2c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ti-RNA autoantibodies. Symbols represent individual mice. One- two independent experiments. n=5-9 mice/grp. Bars indicate mean ± SEM; [2 way ANOVA]; *p &lt; 0.05, **p &lt; 0.01, ***p &lt; 0.001, ****p &lt; 0.0001.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BB38662-DFFA-5D97-92D5-AC8B47111DA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27144"/>
          <a:stretch/>
        </p:blipFill>
        <p:spPr>
          <a:xfrm>
            <a:off x="986669" y="2629546"/>
            <a:ext cx="1632744" cy="120033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B155C6F-DCFC-CEB7-9F9B-D8F70C2A30AE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b="27144"/>
          <a:stretch/>
        </p:blipFill>
        <p:spPr>
          <a:xfrm>
            <a:off x="2563532" y="2629544"/>
            <a:ext cx="1625692" cy="120032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0DDD964-C0B9-79D3-2843-89465DAC2C35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b="26079"/>
          <a:stretch/>
        </p:blipFill>
        <p:spPr>
          <a:xfrm>
            <a:off x="4125839" y="2629543"/>
            <a:ext cx="1616612" cy="120032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1EED7E9-8C66-F293-DF62-8051377BBC41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r="34456"/>
          <a:stretch/>
        </p:blipFill>
        <p:spPr>
          <a:xfrm>
            <a:off x="832266" y="771829"/>
            <a:ext cx="1640249" cy="166174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BF06C1A-AFE0-4542-32EF-1B9467C15B61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r="33657"/>
          <a:stretch/>
        </p:blipFill>
        <p:spPr>
          <a:xfrm>
            <a:off x="2365989" y="660683"/>
            <a:ext cx="1649210" cy="177288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FAC1F97-8C3F-16DD-C5DD-E04373F20AB8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r="34014"/>
          <a:stretch/>
        </p:blipFill>
        <p:spPr>
          <a:xfrm>
            <a:off x="3869839" y="777022"/>
            <a:ext cx="1649210" cy="1656549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3F700CC-9973-246A-9608-B8DFE568FCEC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r="33891"/>
          <a:stretch/>
        </p:blipFill>
        <p:spPr>
          <a:xfrm>
            <a:off x="5442396" y="777021"/>
            <a:ext cx="1649210" cy="165655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0310229-C0A8-1605-8D6C-316B5FF6C185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66663" b="63506"/>
          <a:stretch/>
        </p:blipFill>
        <p:spPr>
          <a:xfrm>
            <a:off x="5988941" y="2433776"/>
            <a:ext cx="901687" cy="655438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F164AB3A-FB05-66D5-5C28-729C0FB05DAB}"/>
              </a:ext>
            </a:extLst>
          </p:cNvPr>
          <p:cNvSpPr txBox="1"/>
          <p:nvPr/>
        </p:nvSpPr>
        <p:spPr>
          <a:xfrm>
            <a:off x="823305" y="58716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12C89D3-5DB8-A7C7-1DEC-D405C4B2BF70}"/>
              </a:ext>
            </a:extLst>
          </p:cNvPr>
          <p:cNvSpPr txBox="1"/>
          <p:nvPr/>
        </p:nvSpPr>
        <p:spPr>
          <a:xfrm>
            <a:off x="2280859" y="58716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434F22E-766C-C7F3-4FC9-38B83F965150}"/>
              </a:ext>
            </a:extLst>
          </p:cNvPr>
          <p:cNvSpPr txBox="1"/>
          <p:nvPr/>
        </p:nvSpPr>
        <p:spPr>
          <a:xfrm>
            <a:off x="3931052" y="58716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031E0F0-802F-D061-6FAE-CC9AF5AD0DE8}"/>
              </a:ext>
            </a:extLst>
          </p:cNvPr>
          <p:cNvSpPr txBox="1"/>
          <p:nvPr/>
        </p:nvSpPr>
        <p:spPr>
          <a:xfrm>
            <a:off x="5442396" y="59235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6045AFB-BB72-4477-9868-5EDF3FAE4653}"/>
              </a:ext>
            </a:extLst>
          </p:cNvPr>
          <p:cNvSpPr txBox="1"/>
          <p:nvPr/>
        </p:nvSpPr>
        <p:spPr>
          <a:xfrm>
            <a:off x="832292" y="2340274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1979C6E-A58D-564C-8394-15345D7CA722}"/>
              </a:ext>
            </a:extLst>
          </p:cNvPr>
          <p:cNvSpPr txBox="1"/>
          <p:nvPr/>
        </p:nvSpPr>
        <p:spPr>
          <a:xfrm>
            <a:off x="2325144" y="234027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A2D39B1-3C9C-490E-3E95-6A227D891709}"/>
              </a:ext>
            </a:extLst>
          </p:cNvPr>
          <p:cNvSpPr txBox="1"/>
          <p:nvPr/>
        </p:nvSpPr>
        <p:spPr>
          <a:xfrm>
            <a:off x="4015351" y="22607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E92FA2E-9C38-7B47-9A6D-27D7062A49CC}"/>
              </a:ext>
            </a:extLst>
          </p:cNvPr>
          <p:cNvSpPr txBox="1"/>
          <p:nvPr/>
        </p:nvSpPr>
        <p:spPr>
          <a:xfrm>
            <a:off x="1336670" y="3795019"/>
            <a:ext cx="10118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Calibri" panose="020F0502020204030204" pitchFamily="34" charset="0"/>
                <a:cs typeface="Calibri" panose="020F0502020204030204" pitchFamily="34" charset="0"/>
              </a:rPr>
              <a:t>NCD                     HF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797AEFC-2854-9450-350A-310399513360}"/>
              </a:ext>
            </a:extLst>
          </p:cNvPr>
          <p:cNvSpPr txBox="1"/>
          <p:nvPr/>
        </p:nvSpPr>
        <p:spPr>
          <a:xfrm>
            <a:off x="2912441" y="3783130"/>
            <a:ext cx="10118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Calibri" panose="020F0502020204030204" pitchFamily="34" charset="0"/>
                <a:cs typeface="Calibri" panose="020F0502020204030204" pitchFamily="34" charset="0"/>
              </a:rPr>
              <a:t>NCD                     HFD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BA21417-AEBB-70ED-BB9E-698DC042E55E}"/>
              </a:ext>
            </a:extLst>
          </p:cNvPr>
          <p:cNvSpPr txBox="1"/>
          <p:nvPr/>
        </p:nvSpPr>
        <p:spPr>
          <a:xfrm>
            <a:off x="4482252" y="3778841"/>
            <a:ext cx="10118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Calibri" panose="020F0502020204030204" pitchFamily="34" charset="0"/>
                <a:cs typeface="Calibri" panose="020F0502020204030204" pitchFamily="34" charset="0"/>
              </a:rPr>
              <a:t>NCD                     HFD</a:t>
            </a:r>
          </a:p>
        </p:txBody>
      </p:sp>
    </p:spTree>
    <p:extLst>
      <p:ext uri="{BB962C8B-B14F-4D97-AF65-F5344CB8AC3E}">
        <p14:creationId xmlns:p14="http://schemas.microsoft.com/office/powerpoint/2010/main" val="13837465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401FA53-2C52-D95E-3E23-86121AC57E8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031" t="5502" r="1119" b="1595"/>
          <a:stretch/>
        </p:blipFill>
        <p:spPr>
          <a:xfrm>
            <a:off x="983226" y="1002889"/>
            <a:ext cx="5368414" cy="4572001"/>
          </a:xfrm>
          <a:prstGeom prst="rect">
            <a:avLst/>
          </a:prstGeom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1859640-C67D-36E2-62AC-59B239455498}"/>
              </a:ext>
            </a:extLst>
          </p:cNvPr>
          <p:cNvSpPr txBox="1"/>
          <p:nvPr/>
        </p:nvSpPr>
        <p:spPr>
          <a:xfrm>
            <a:off x="228600" y="5799314"/>
            <a:ext cx="7315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8. Gating strategy used to identify T-bet+ CD11c+ B cells, 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, and PD-1</a:t>
            </a:r>
            <a:r>
              <a:rPr lang="en-US" sz="1200" b="1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XCR5+/- CD4+ T cells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ting strategy used in flow cytometric analysis to identity T-bet+ CD11c+ B cells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, PD-1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XCR5- CD4+ T</a:t>
            </a:r>
            <a:r>
              <a:rPr lang="en-US" sz="12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 (yellow gate) and PD-1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XCR5+ T</a:t>
            </a:r>
            <a:r>
              <a:rPr lang="en-US" sz="12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H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 (blue gate)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1524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736</TotalTime>
  <Words>1890</Words>
  <Application>Microsoft Macintosh PowerPoint</Application>
  <PresentationFormat>Custom</PresentationFormat>
  <Paragraphs>128</Paragraphs>
  <Slides>9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7" baseType="lpstr">
      <vt:lpstr>Aptos</vt:lpstr>
      <vt:lpstr>Aptos Display</vt:lpstr>
      <vt:lpstr>Arial</vt:lpstr>
      <vt:lpstr>Calibri</vt:lpstr>
      <vt:lpstr>Symbol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njamin Enslow</dc:creator>
  <cp:lastModifiedBy>Leadbetter, Elizabeth</cp:lastModifiedBy>
  <cp:revision>84</cp:revision>
  <dcterms:created xsi:type="dcterms:W3CDTF">2024-08-19T12:08:47Z</dcterms:created>
  <dcterms:modified xsi:type="dcterms:W3CDTF">2025-09-01T21:13:22Z</dcterms:modified>
</cp:coreProperties>
</file>